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138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New%20Microsoft%20Office%20Excel%20Workshee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New%20Microsoft%20Office%20Excel%20Workshee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sz="1400" b="1" i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orrected mortality (</a:t>
            </a:r>
            <a:r>
              <a:rPr lang="en-US" sz="1400" b="1" i="0" u="none" strike="noStrike" baseline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% ) </a:t>
            </a:r>
            <a:r>
              <a:rPr lang="en-US" sz="1400" b="1" i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sz="1400" b="1" i="1" u="none" strike="noStrike" baseline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. </a:t>
            </a:r>
            <a:r>
              <a:rPr lang="en-US" sz="1400" b="1" i="1" u="none" strike="noStrike" baseline="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runcatus</a:t>
            </a:r>
            <a:r>
              <a:rPr lang="en-US" sz="1400" b="1" i="1" u="none" strike="noStrike" baseline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b="1" i="0" u="none" strike="noStrike" baseline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aused by </a:t>
            </a:r>
            <a:r>
              <a:rPr lang="en-US" sz="1400" b="1" i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B </a:t>
            </a:r>
            <a:r>
              <a:rPr lang="en-US" sz="1400" b="1" i="1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bassiana</a:t>
            </a:r>
            <a:endParaRPr lang="en-US" sz="1400" b="1" i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E$5</c:f>
              <c:strCache>
                <c:ptCount val="1"/>
                <c:pt idx="0">
                  <c:v>3 DA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D$42:$D$72</c:f>
                <c:numCache>
                  <c:formatCode>General</c:formatCode>
                  <c:ptCount val="31"/>
                  <c:pt idx="0">
                    <c:v>2.34</c:v>
                  </c:pt>
                  <c:pt idx="1">
                    <c:v>3.74</c:v>
                  </c:pt>
                  <c:pt idx="2">
                    <c:v>2.4899999999999998</c:v>
                  </c:pt>
                  <c:pt idx="3">
                    <c:v>1.8900000000000001</c:v>
                  </c:pt>
                  <c:pt idx="4">
                    <c:v>3.51</c:v>
                  </c:pt>
                  <c:pt idx="5">
                    <c:v>3.92</c:v>
                  </c:pt>
                  <c:pt idx="6">
                    <c:v>2.36</c:v>
                  </c:pt>
                  <c:pt idx="7">
                    <c:v>3.2</c:v>
                  </c:pt>
                  <c:pt idx="8">
                    <c:v>2.5099999999999998</c:v>
                  </c:pt>
                  <c:pt idx="9">
                    <c:v>1.24</c:v>
                  </c:pt>
                  <c:pt idx="10">
                    <c:v>1.9700000000000009</c:v>
                  </c:pt>
                  <c:pt idx="11">
                    <c:v>4.6599999999999975</c:v>
                  </c:pt>
                  <c:pt idx="12">
                    <c:v>2.6</c:v>
                  </c:pt>
                  <c:pt idx="13">
                    <c:v>1.3900000000000001</c:v>
                  </c:pt>
                  <c:pt idx="14">
                    <c:v>4.91</c:v>
                  </c:pt>
                  <c:pt idx="15">
                    <c:v>1.8</c:v>
                  </c:pt>
                  <c:pt idx="16">
                    <c:v>2.12</c:v>
                  </c:pt>
                  <c:pt idx="17">
                    <c:v>2.27</c:v>
                  </c:pt>
                  <c:pt idx="18">
                    <c:v>2.25</c:v>
                  </c:pt>
                  <c:pt idx="19">
                    <c:v>1.1200000000000001</c:v>
                  </c:pt>
                  <c:pt idx="20">
                    <c:v>4.1599999999999975</c:v>
                  </c:pt>
                  <c:pt idx="21">
                    <c:v>2.15</c:v>
                  </c:pt>
                  <c:pt idx="22">
                    <c:v>2.52</c:v>
                  </c:pt>
                  <c:pt idx="23">
                    <c:v>2.48</c:v>
                  </c:pt>
                  <c:pt idx="24">
                    <c:v>2.9</c:v>
                  </c:pt>
                  <c:pt idx="25">
                    <c:v>3.18</c:v>
                  </c:pt>
                  <c:pt idx="26">
                    <c:v>2.1800000000000002</c:v>
                  </c:pt>
                  <c:pt idx="27">
                    <c:v>2.92</c:v>
                  </c:pt>
                  <c:pt idx="28">
                    <c:v>1.49</c:v>
                  </c:pt>
                  <c:pt idx="29">
                    <c:v>2.66</c:v>
                  </c:pt>
                  <c:pt idx="30">
                    <c:v>2.36</c:v>
                  </c:pt>
                </c:numCache>
              </c:numRef>
            </c:plus>
            <c:minus>
              <c:numRef>
                <c:f>Sheet1!$D$42:$D$72</c:f>
                <c:numCache>
                  <c:formatCode>General</c:formatCode>
                  <c:ptCount val="31"/>
                  <c:pt idx="0">
                    <c:v>2.34</c:v>
                  </c:pt>
                  <c:pt idx="1">
                    <c:v>3.74</c:v>
                  </c:pt>
                  <c:pt idx="2">
                    <c:v>2.4899999999999998</c:v>
                  </c:pt>
                  <c:pt idx="3">
                    <c:v>1.8900000000000001</c:v>
                  </c:pt>
                  <c:pt idx="4">
                    <c:v>3.51</c:v>
                  </c:pt>
                  <c:pt idx="5">
                    <c:v>3.92</c:v>
                  </c:pt>
                  <c:pt idx="6">
                    <c:v>2.36</c:v>
                  </c:pt>
                  <c:pt idx="7">
                    <c:v>3.2</c:v>
                  </c:pt>
                  <c:pt idx="8">
                    <c:v>2.5099999999999998</c:v>
                  </c:pt>
                  <c:pt idx="9">
                    <c:v>1.24</c:v>
                  </c:pt>
                  <c:pt idx="10">
                    <c:v>1.9700000000000009</c:v>
                  </c:pt>
                  <c:pt idx="11">
                    <c:v>4.6599999999999975</c:v>
                  </c:pt>
                  <c:pt idx="12">
                    <c:v>2.6</c:v>
                  </c:pt>
                  <c:pt idx="13">
                    <c:v>1.3900000000000001</c:v>
                  </c:pt>
                  <c:pt idx="14">
                    <c:v>4.91</c:v>
                  </c:pt>
                  <c:pt idx="15">
                    <c:v>1.8</c:v>
                  </c:pt>
                  <c:pt idx="16">
                    <c:v>2.12</c:v>
                  </c:pt>
                  <c:pt idx="17">
                    <c:v>2.27</c:v>
                  </c:pt>
                  <c:pt idx="18">
                    <c:v>2.25</c:v>
                  </c:pt>
                  <c:pt idx="19">
                    <c:v>1.1200000000000001</c:v>
                  </c:pt>
                  <c:pt idx="20">
                    <c:v>4.1599999999999975</c:v>
                  </c:pt>
                  <c:pt idx="21">
                    <c:v>2.15</c:v>
                  </c:pt>
                  <c:pt idx="22">
                    <c:v>2.52</c:v>
                  </c:pt>
                  <c:pt idx="23">
                    <c:v>2.48</c:v>
                  </c:pt>
                  <c:pt idx="24">
                    <c:v>2.9</c:v>
                  </c:pt>
                  <c:pt idx="25">
                    <c:v>3.18</c:v>
                  </c:pt>
                  <c:pt idx="26">
                    <c:v>2.1800000000000002</c:v>
                  </c:pt>
                  <c:pt idx="27">
                    <c:v>2.92</c:v>
                  </c:pt>
                  <c:pt idx="28">
                    <c:v>1.49</c:v>
                  </c:pt>
                  <c:pt idx="29">
                    <c:v>2.66</c:v>
                  </c:pt>
                  <c:pt idx="30">
                    <c:v>2.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6:$D$36</c:f>
              <c:strCache>
                <c:ptCount val="31"/>
                <c:pt idx="0">
                  <c:v>Bb1</c:v>
                </c:pt>
                <c:pt idx="1">
                  <c:v>Bb2</c:v>
                </c:pt>
                <c:pt idx="2">
                  <c:v>Bb3</c:v>
                </c:pt>
                <c:pt idx="3">
                  <c:v>Bb4</c:v>
                </c:pt>
                <c:pt idx="4">
                  <c:v>Bb5</c:v>
                </c:pt>
                <c:pt idx="5">
                  <c:v>BB6</c:v>
                </c:pt>
                <c:pt idx="6">
                  <c:v>Bb7</c:v>
                </c:pt>
                <c:pt idx="7">
                  <c:v>Bb8</c:v>
                </c:pt>
                <c:pt idx="8">
                  <c:v>Bb9</c:v>
                </c:pt>
                <c:pt idx="9">
                  <c:v>Bb10</c:v>
                </c:pt>
                <c:pt idx="10">
                  <c:v>Bb11</c:v>
                </c:pt>
                <c:pt idx="11">
                  <c:v>Bb12</c:v>
                </c:pt>
                <c:pt idx="12">
                  <c:v>Bb13</c:v>
                </c:pt>
                <c:pt idx="13">
                  <c:v>Bb14</c:v>
                </c:pt>
                <c:pt idx="14">
                  <c:v>Bb15</c:v>
                </c:pt>
                <c:pt idx="15">
                  <c:v>Bb16</c:v>
                </c:pt>
                <c:pt idx="16">
                  <c:v>Bb17</c:v>
                </c:pt>
                <c:pt idx="17">
                  <c:v>Bb18</c:v>
                </c:pt>
                <c:pt idx="18">
                  <c:v>Bb19</c:v>
                </c:pt>
                <c:pt idx="19">
                  <c:v>Bb20</c:v>
                </c:pt>
                <c:pt idx="20">
                  <c:v>Bb21</c:v>
                </c:pt>
                <c:pt idx="21">
                  <c:v>Bb22</c:v>
                </c:pt>
                <c:pt idx="22">
                  <c:v>Bb23</c:v>
                </c:pt>
                <c:pt idx="23">
                  <c:v>Bb24</c:v>
                </c:pt>
                <c:pt idx="24">
                  <c:v>Bb25</c:v>
                </c:pt>
                <c:pt idx="25">
                  <c:v>Bb26</c:v>
                </c:pt>
                <c:pt idx="26">
                  <c:v>Bb27</c:v>
                </c:pt>
                <c:pt idx="27">
                  <c:v>Bb28</c:v>
                </c:pt>
                <c:pt idx="28">
                  <c:v>Bb29</c:v>
                </c:pt>
                <c:pt idx="29">
                  <c:v>Bb30</c:v>
                </c:pt>
                <c:pt idx="30">
                  <c:v>Beveroz</c:v>
                </c:pt>
              </c:strCache>
            </c:strRef>
          </c:cat>
          <c:val>
            <c:numRef>
              <c:f>Sheet1!$E$6:$E$36</c:f>
              <c:numCache>
                <c:formatCode>General</c:formatCode>
                <c:ptCount val="31"/>
                <c:pt idx="0">
                  <c:v>65.09</c:v>
                </c:pt>
                <c:pt idx="1">
                  <c:v>50.88</c:v>
                </c:pt>
                <c:pt idx="2">
                  <c:v>64.149999999999991</c:v>
                </c:pt>
                <c:pt idx="3">
                  <c:v>18.36</c:v>
                </c:pt>
                <c:pt idx="4">
                  <c:v>6.49</c:v>
                </c:pt>
                <c:pt idx="5">
                  <c:v>95.669999999999987</c:v>
                </c:pt>
                <c:pt idx="6">
                  <c:v>67.36999999999999</c:v>
                </c:pt>
                <c:pt idx="7">
                  <c:v>5.0199999999999996</c:v>
                </c:pt>
                <c:pt idx="8">
                  <c:v>60.760000000000012</c:v>
                </c:pt>
                <c:pt idx="9">
                  <c:v>30.41</c:v>
                </c:pt>
                <c:pt idx="10">
                  <c:v>37.020000000000003</c:v>
                </c:pt>
                <c:pt idx="11">
                  <c:v>90.06</c:v>
                </c:pt>
                <c:pt idx="12">
                  <c:v>75.09</c:v>
                </c:pt>
                <c:pt idx="13">
                  <c:v>18.420000000000002</c:v>
                </c:pt>
                <c:pt idx="14">
                  <c:v>93.45</c:v>
                </c:pt>
                <c:pt idx="15">
                  <c:v>30.47</c:v>
                </c:pt>
                <c:pt idx="16">
                  <c:v>66.36999999999999</c:v>
                </c:pt>
                <c:pt idx="17">
                  <c:v>28.19</c:v>
                </c:pt>
                <c:pt idx="18">
                  <c:v>52.220000000000013</c:v>
                </c:pt>
                <c:pt idx="19">
                  <c:v>72.81</c:v>
                </c:pt>
                <c:pt idx="20">
                  <c:v>8.7100000000000009</c:v>
                </c:pt>
                <c:pt idx="21">
                  <c:v>32.46</c:v>
                </c:pt>
                <c:pt idx="22">
                  <c:v>24.04</c:v>
                </c:pt>
                <c:pt idx="23">
                  <c:v>86.9</c:v>
                </c:pt>
                <c:pt idx="24">
                  <c:v>48.65</c:v>
                </c:pt>
                <c:pt idx="25">
                  <c:v>84.85</c:v>
                </c:pt>
                <c:pt idx="26">
                  <c:v>78.3</c:v>
                </c:pt>
                <c:pt idx="27">
                  <c:v>80.349999999999994</c:v>
                </c:pt>
                <c:pt idx="28">
                  <c:v>71.64</c:v>
                </c:pt>
                <c:pt idx="29">
                  <c:v>83.63</c:v>
                </c:pt>
                <c:pt idx="30">
                  <c:v>67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097-4504-ADBD-32A6906EB71B}"/>
            </c:ext>
          </c:extLst>
        </c:ser>
        <c:ser>
          <c:idx val="1"/>
          <c:order val="1"/>
          <c:tx>
            <c:strRef>
              <c:f>Sheet1!$F$5</c:f>
              <c:strCache>
                <c:ptCount val="1"/>
                <c:pt idx="0">
                  <c:v>5 DAI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E$42:$E$72</c:f>
                <c:numCache>
                  <c:formatCode>General</c:formatCode>
                  <c:ptCount val="31"/>
                  <c:pt idx="0">
                    <c:v>2.2200000000000002</c:v>
                  </c:pt>
                  <c:pt idx="1">
                    <c:v>1.59</c:v>
                  </c:pt>
                  <c:pt idx="2">
                    <c:v>1.8800000000000001</c:v>
                  </c:pt>
                  <c:pt idx="3">
                    <c:v>1.41</c:v>
                  </c:pt>
                  <c:pt idx="4">
                    <c:v>2.4499999999999997</c:v>
                  </c:pt>
                  <c:pt idx="5">
                    <c:v>3.3099999999999987</c:v>
                  </c:pt>
                  <c:pt idx="6">
                    <c:v>2.46</c:v>
                  </c:pt>
                  <c:pt idx="7">
                    <c:v>4.37</c:v>
                  </c:pt>
                  <c:pt idx="8">
                    <c:v>1.9200000000000008</c:v>
                  </c:pt>
                  <c:pt idx="9">
                    <c:v>1.45</c:v>
                  </c:pt>
                  <c:pt idx="10">
                    <c:v>2.14</c:v>
                  </c:pt>
                  <c:pt idx="11">
                    <c:v>4.7300000000000004</c:v>
                  </c:pt>
                  <c:pt idx="12">
                    <c:v>1.52</c:v>
                  </c:pt>
                  <c:pt idx="13">
                    <c:v>2.11</c:v>
                  </c:pt>
                  <c:pt idx="14">
                    <c:v>3.96</c:v>
                  </c:pt>
                  <c:pt idx="15">
                    <c:v>1.8900000000000001</c:v>
                  </c:pt>
                  <c:pt idx="16">
                    <c:v>1.8900000000000001</c:v>
                  </c:pt>
                  <c:pt idx="17">
                    <c:v>1.760000000000002</c:v>
                  </c:pt>
                  <c:pt idx="18">
                    <c:v>2.79</c:v>
                  </c:pt>
                  <c:pt idx="19">
                    <c:v>1.7100000000000017</c:v>
                  </c:pt>
                  <c:pt idx="20">
                    <c:v>0.99</c:v>
                  </c:pt>
                  <c:pt idx="21">
                    <c:v>1.86</c:v>
                  </c:pt>
                  <c:pt idx="22">
                    <c:v>1.82</c:v>
                  </c:pt>
                  <c:pt idx="23">
                    <c:v>3.1</c:v>
                  </c:pt>
                  <c:pt idx="24">
                    <c:v>1.139999999999997</c:v>
                  </c:pt>
                  <c:pt idx="25">
                    <c:v>2.34</c:v>
                  </c:pt>
                  <c:pt idx="26">
                    <c:v>2.8299999999999987</c:v>
                  </c:pt>
                  <c:pt idx="27">
                    <c:v>1.62</c:v>
                  </c:pt>
                  <c:pt idx="28">
                    <c:v>0.880000000000001</c:v>
                  </c:pt>
                  <c:pt idx="29">
                    <c:v>2.48</c:v>
                  </c:pt>
                  <c:pt idx="30">
                    <c:v>2.36</c:v>
                  </c:pt>
                </c:numCache>
              </c:numRef>
            </c:plus>
            <c:minus>
              <c:numRef>
                <c:f>Sheet1!$E$42:$E$72</c:f>
                <c:numCache>
                  <c:formatCode>General</c:formatCode>
                  <c:ptCount val="31"/>
                  <c:pt idx="0">
                    <c:v>2.2200000000000002</c:v>
                  </c:pt>
                  <c:pt idx="1">
                    <c:v>1.59</c:v>
                  </c:pt>
                  <c:pt idx="2">
                    <c:v>1.8800000000000001</c:v>
                  </c:pt>
                  <c:pt idx="3">
                    <c:v>1.41</c:v>
                  </c:pt>
                  <c:pt idx="4">
                    <c:v>2.4499999999999997</c:v>
                  </c:pt>
                  <c:pt idx="5">
                    <c:v>3.3099999999999987</c:v>
                  </c:pt>
                  <c:pt idx="6">
                    <c:v>2.46</c:v>
                  </c:pt>
                  <c:pt idx="7">
                    <c:v>4.37</c:v>
                  </c:pt>
                  <c:pt idx="8">
                    <c:v>1.9200000000000008</c:v>
                  </c:pt>
                  <c:pt idx="9">
                    <c:v>1.45</c:v>
                  </c:pt>
                  <c:pt idx="10">
                    <c:v>2.14</c:v>
                  </c:pt>
                  <c:pt idx="11">
                    <c:v>4.7300000000000004</c:v>
                  </c:pt>
                  <c:pt idx="12">
                    <c:v>1.52</c:v>
                  </c:pt>
                  <c:pt idx="13">
                    <c:v>2.11</c:v>
                  </c:pt>
                  <c:pt idx="14">
                    <c:v>3.96</c:v>
                  </c:pt>
                  <c:pt idx="15">
                    <c:v>1.8900000000000001</c:v>
                  </c:pt>
                  <c:pt idx="16">
                    <c:v>1.8900000000000001</c:v>
                  </c:pt>
                  <c:pt idx="17">
                    <c:v>1.760000000000002</c:v>
                  </c:pt>
                  <c:pt idx="18">
                    <c:v>2.79</c:v>
                  </c:pt>
                  <c:pt idx="19">
                    <c:v>1.7100000000000017</c:v>
                  </c:pt>
                  <c:pt idx="20">
                    <c:v>0.99</c:v>
                  </c:pt>
                  <c:pt idx="21">
                    <c:v>1.86</c:v>
                  </c:pt>
                  <c:pt idx="22">
                    <c:v>1.82</c:v>
                  </c:pt>
                  <c:pt idx="23">
                    <c:v>3.1</c:v>
                  </c:pt>
                  <c:pt idx="24">
                    <c:v>1.139999999999997</c:v>
                  </c:pt>
                  <c:pt idx="25">
                    <c:v>2.34</c:v>
                  </c:pt>
                  <c:pt idx="26">
                    <c:v>2.8299999999999987</c:v>
                  </c:pt>
                  <c:pt idx="27">
                    <c:v>1.62</c:v>
                  </c:pt>
                  <c:pt idx="28">
                    <c:v>0.880000000000001</c:v>
                  </c:pt>
                  <c:pt idx="29">
                    <c:v>2.48</c:v>
                  </c:pt>
                  <c:pt idx="30">
                    <c:v>2.3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6:$D$36</c:f>
              <c:strCache>
                <c:ptCount val="31"/>
                <c:pt idx="0">
                  <c:v>Bb1</c:v>
                </c:pt>
                <c:pt idx="1">
                  <c:v>Bb2</c:v>
                </c:pt>
                <c:pt idx="2">
                  <c:v>Bb3</c:v>
                </c:pt>
                <c:pt idx="3">
                  <c:v>Bb4</c:v>
                </c:pt>
                <c:pt idx="4">
                  <c:v>Bb5</c:v>
                </c:pt>
                <c:pt idx="5">
                  <c:v>BB6</c:v>
                </c:pt>
                <c:pt idx="6">
                  <c:v>Bb7</c:v>
                </c:pt>
                <c:pt idx="7">
                  <c:v>Bb8</c:v>
                </c:pt>
                <c:pt idx="8">
                  <c:v>Bb9</c:v>
                </c:pt>
                <c:pt idx="9">
                  <c:v>Bb10</c:v>
                </c:pt>
                <c:pt idx="10">
                  <c:v>Bb11</c:v>
                </c:pt>
                <c:pt idx="11">
                  <c:v>Bb12</c:v>
                </c:pt>
                <c:pt idx="12">
                  <c:v>Bb13</c:v>
                </c:pt>
                <c:pt idx="13">
                  <c:v>Bb14</c:v>
                </c:pt>
                <c:pt idx="14">
                  <c:v>Bb15</c:v>
                </c:pt>
                <c:pt idx="15">
                  <c:v>Bb16</c:v>
                </c:pt>
                <c:pt idx="16">
                  <c:v>Bb17</c:v>
                </c:pt>
                <c:pt idx="17">
                  <c:v>Bb18</c:v>
                </c:pt>
                <c:pt idx="18">
                  <c:v>Bb19</c:v>
                </c:pt>
                <c:pt idx="19">
                  <c:v>Bb20</c:v>
                </c:pt>
                <c:pt idx="20">
                  <c:v>Bb21</c:v>
                </c:pt>
                <c:pt idx="21">
                  <c:v>Bb22</c:v>
                </c:pt>
                <c:pt idx="22">
                  <c:v>Bb23</c:v>
                </c:pt>
                <c:pt idx="23">
                  <c:v>Bb24</c:v>
                </c:pt>
                <c:pt idx="24">
                  <c:v>Bb25</c:v>
                </c:pt>
                <c:pt idx="25">
                  <c:v>Bb26</c:v>
                </c:pt>
                <c:pt idx="26">
                  <c:v>Bb27</c:v>
                </c:pt>
                <c:pt idx="27">
                  <c:v>Bb28</c:v>
                </c:pt>
                <c:pt idx="28">
                  <c:v>Bb29</c:v>
                </c:pt>
                <c:pt idx="29">
                  <c:v>Bb30</c:v>
                </c:pt>
                <c:pt idx="30">
                  <c:v>Beveroz</c:v>
                </c:pt>
              </c:strCache>
            </c:strRef>
          </c:cat>
          <c:val>
            <c:numRef>
              <c:f>Sheet1!$F$6:$F$36</c:f>
              <c:numCache>
                <c:formatCode>General</c:formatCode>
                <c:ptCount val="31"/>
                <c:pt idx="0">
                  <c:v>68.3</c:v>
                </c:pt>
                <c:pt idx="1">
                  <c:v>65.09</c:v>
                </c:pt>
                <c:pt idx="2">
                  <c:v>65.09</c:v>
                </c:pt>
                <c:pt idx="3">
                  <c:v>23.86</c:v>
                </c:pt>
                <c:pt idx="4">
                  <c:v>11.870000000000006</c:v>
                </c:pt>
                <c:pt idx="5">
                  <c:v>96.73</c:v>
                </c:pt>
                <c:pt idx="6">
                  <c:v>72.86999999999999</c:v>
                </c:pt>
                <c:pt idx="7">
                  <c:v>5.44</c:v>
                </c:pt>
                <c:pt idx="8">
                  <c:v>63.98</c:v>
                </c:pt>
                <c:pt idx="9">
                  <c:v>33.800000000000004</c:v>
                </c:pt>
                <c:pt idx="10">
                  <c:v>40.18</c:v>
                </c:pt>
                <c:pt idx="11">
                  <c:v>93.45</c:v>
                </c:pt>
                <c:pt idx="12">
                  <c:v>76.08</c:v>
                </c:pt>
                <c:pt idx="13">
                  <c:v>22.810000000000031</c:v>
                </c:pt>
                <c:pt idx="14">
                  <c:v>95.56</c:v>
                </c:pt>
                <c:pt idx="15">
                  <c:v>31.459999999999987</c:v>
                </c:pt>
                <c:pt idx="16">
                  <c:v>68.540000000000006</c:v>
                </c:pt>
                <c:pt idx="17">
                  <c:v>30.47</c:v>
                </c:pt>
                <c:pt idx="18">
                  <c:v>65.440000000000026</c:v>
                </c:pt>
                <c:pt idx="19">
                  <c:v>73.98</c:v>
                </c:pt>
                <c:pt idx="20">
                  <c:v>11.99</c:v>
                </c:pt>
                <c:pt idx="21">
                  <c:v>33.68</c:v>
                </c:pt>
                <c:pt idx="22">
                  <c:v>24.97</c:v>
                </c:pt>
                <c:pt idx="23">
                  <c:v>89.11999999999999</c:v>
                </c:pt>
                <c:pt idx="24">
                  <c:v>57.6</c:v>
                </c:pt>
                <c:pt idx="25">
                  <c:v>87.02</c:v>
                </c:pt>
                <c:pt idx="26">
                  <c:v>82.51</c:v>
                </c:pt>
                <c:pt idx="27">
                  <c:v>82.57</c:v>
                </c:pt>
                <c:pt idx="28">
                  <c:v>76.08</c:v>
                </c:pt>
                <c:pt idx="29">
                  <c:v>84.679999999999978</c:v>
                </c:pt>
                <c:pt idx="30">
                  <c:v>71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097-4504-ADBD-32A6906EB71B}"/>
            </c:ext>
          </c:extLst>
        </c:ser>
        <c:ser>
          <c:idx val="2"/>
          <c:order val="2"/>
          <c:tx>
            <c:strRef>
              <c:f>Sheet1!$G$5</c:f>
              <c:strCache>
                <c:ptCount val="1"/>
                <c:pt idx="0">
                  <c:v>7 DAI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F$42:$F$72</c:f>
                <c:numCache>
                  <c:formatCode>General</c:formatCode>
                  <c:ptCount val="31"/>
                  <c:pt idx="0">
                    <c:v>1.55</c:v>
                  </c:pt>
                  <c:pt idx="1">
                    <c:v>1.3800000000000001</c:v>
                  </c:pt>
                  <c:pt idx="2">
                    <c:v>1.55</c:v>
                  </c:pt>
                  <c:pt idx="3">
                    <c:v>1.7800000000000022</c:v>
                  </c:pt>
                  <c:pt idx="4">
                    <c:v>1.8800000000000001</c:v>
                  </c:pt>
                  <c:pt idx="5">
                    <c:v>3.34</c:v>
                  </c:pt>
                  <c:pt idx="6">
                    <c:v>2.06</c:v>
                  </c:pt>
                  <c:pt idx="7">
                    <c:v>3.51</c:v>
                  </c:pt>
                  <c:pt idx="8">
                    <c:v>1.6300000000000001</c:v>
                  </c:pt>
                  <c:pt idx="9">
                    <c:v>1.55</c:v>
                  </c:pt>
                  <c:pt idx="10">
                    <c:v>1.34</c:v>
                  </c:pt>
                  <c:pt idx="11">
                    <c:v>4.41</c:v>
                  </c:pt>
                  <c:pt idx="12">
                    <c:v>1.57</c:v>
                  </c:pt>
                  <c:pt idx="13">
                    <c:v>1.7700000000000022</c:v>
                  </c:pt>
                  <c:pt idx="14">
                    <c:v>3.3099999999999987</c:v>
                  </c:pt>
                  <c:pt idx="15">
                    <c:v>1.4</c:v>
                  </c:pt>
                  <c:pt idx="16">
                    <c:v>1.41</c:v>
                  </c:pt>
                  <c:pt idx="17">
                    <c:v>1.7000000000000017</c:v>
                  </c:pt>
                  <c:pt idx="18">
                    <c:v>1.7100000000000017</c:v>
                  </c:pt>
                  <c:pt idx="19">
                    <c:v>1.6</c:v>
                  </c:pt>
                  <c:pt idx="20">
                    <c:v>8.14</c:v>
                  </c:pt>
                  <c:pt idx="21">
                    <c:v>1.26</c:v>
                  </c:pt>
                  <c:pt idx="22">
                    <c:v>1.82</c:v>
                  </c:pt>
                  <c:pt idx="23">
                    <c:v>3.1</c:v>
                  </c:pt>
                  <c:pt idx="24">
                    <c:v>0.62000000000000133</c:v>
                  </c:pt>
                  <c:pt idx="25">
                    <c:v>1.9500000000000008</c:v>
                  </c:pt>
                  <c:pt idx="26">
                    <c:v>2.66</c:v>
                  </c:pt>
                  <c:pt idx="27">
                    <c:v>1.3800000000000001</c:v>
                  </c:pt>
                  <c:pt idx="28">
                    <c:v>0.84000000000000064</c:v>
                  </c:pt>
                  <c:pt idx="29">
                    <c:v>2.0299999999999998</c:v>
                  </c:pt>
                  <c:pt idx="30">
                    <c:v>2.02</c:v>
                  </c:pt>
                </c:numCache>
              </c:numRef>
            </c:plus>
            <c:minus>
              <c:numRef>
                <c:f>Sheet1!$F$42:$F$72</c:f>
                <c:numCache>
                  <c:formatCode>General</c:formatCode>
                  <c:ptCount val="31"/>
                  <c:pt idx="0">
                    <c:v>1.55</c:v>
                  </c:pt>
                  <c:pt idx="1">
                    <c:v>1.3800000000000001</c:v>
                  </c:pt>
                  <c:pt idx="2">
                    <c:v>1.55</c:v>
                  </c:pt>
                  <c:pt idx="3">
                    <c:v>1.7800000000000022</c:v>
                  </c:pt>
                  <c:pt idx="4">
                    <c:v>1.8800000000000001</c:v>
                  </c:pt>
                  <c:pt idx="5">
                    <c:v>3.34</c:v>
                  </c:pt>
                  <c:pt idx="6">
                    <c:v>2.06</c:v>
                  </c:pt>
                  <c:pt idx="7">
                    <c:v>3.51</c:v>
                  </c:pt>
                  <c:pt idx="8">
                    <c:v>1.6300000000000001</c:v>
                  </c:pt>
                  <c:pt idx="9">
                    <c:v>1.55</c:v>
                  </c:pt>
                  <c:pt idx="10">
                    <c:v>1.34</c:v>
                  </c:pt>
                  <c:pt idx="11">
                    <c:v>4.41</c:v>
                  </c:pt>
                  <c:pt idx="12">
                    <c:v>1.57</c:v>
                  </c:pt>
                  <c:pt idx="13">
                    <c:v>1.7700000000000022</c:v>
                  </c:pt>
                  <c:pt idx="14">
                    <c:v>3.3099999999999987</c:v>
                  </c:pt>
                  <c:pt idx="15">
                    <c:v>1.4</c:v>
                  </c:pt>
                  <c:pt idx="16">
                    <c:v>1.41</c:v>
                  </c:pt>
                  <c:pt idx="17">
                    <c:v>1.7000000000000017</c:v>
                  </c:pt>
                  <c:pt idx="18">
                    <c:v>1.7100000000000017</c:v>
                  </c:pt>
                  <c:pt idx="19">
                    <c:v>1.6</c:v>
                  </c:pt>
                  <c:pt idx="20">
                    <c:v>8.14</c:v>
                  </c:pt>
                  <c:pt idx="21">
                    <c:v>1.26</c:v>
                  </c:pt>
                  <c:pt idx="22">
                    <c:v>1.82</c:v>
                  </c:pt>
                  <c:pt idx="23">
                    <c:v>3.1</c:v>
                  </c:pt>
                  <c:pt idx="24">
                    <c:v>0.62000000000000133</c:v>
                  </c:pt>
                  <c:pt idx="25">
                    <c:v>1.9500000000000008</c:v>
                  </c:pt>
                  <c:pt idx="26">
                    <c:v>2.66</c:v>
                  </c:pt>
                  <c:pt idx="27">
                    <c:v>1.3800000000000001</c:v>
                  </c:pt>
                  <c:pt idx="28">
                    <c:v>0.84000000000000064</c:v>
                  </c:pt>
                  <c:pt idx="29">
                    <c:v>2.0299999999999998</c:v>
                  </c:pt>
                  <c:pt idx="30">
                    <c:v>2.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6:$D$36</c:f>
              <c:strCache>
                <c:ptCount val="31"/>
                <c:pt idx="0">
                  <c:v>Bb1</c:v>
                </c:pt>
                <c:pt idx="1">
                  <c:v>Bb2</c:v>
                </c:pt>
                <c:pt idx="2">
                  <c:v>Bb3</c:v>
                </c:pt>
                <c:pt idx="3">
                  <c:v>Bb4</c:v>
                </c:pt>
                <c:pt idx="4">
                  <c:v>Bb5</c:v>
                </c:pt>
                <c:pt idx="5">
                  <c:v>BB6</c:v>
                </c:pt>
                <c:pt idx="6">
                  <c:v>Bb7</c:v>
                </c:pt>
                <c:pt idx="7">
                  <c:v>Bb8</c:v>
                </c:pt>
                <c:pt idx="8">
                  <c:v>Bb9</c:v>
                </c:pt>
                <c:pt idx="9">
                  <c:v>Bb10</c:v>
                </c:pt>
                <c:pt idx="10">
                  <c:v>Bb11</c:v>
                </c:pt>
                <c:pt idx="11">
                  <c:v>Bb12</c:v>
                </c:pt>
                <c:pt idx="12">
                  <c:v>Bb13</c:v>
                </c:pt>
                <c:pt idx="13">
                  <c:v>Bb14</c:v>
                </c:pt>
                <c:pt idx="14">
                  <c:v>Bb15</c:v>
                </c:pt>
                <c:pt idx="15">
                  <c:v>Bb16</c:v>
                </c:pt>
                <c:pt idx="16">
                  <c:v>Bb17</c:v>
                </c:pt>
                <c:pt idx="17">
                  <c:v>Bb18</c:v>
                </c:pt>
                <c:pt idx="18">
                  <c:v>Bb19</c:v>
                </c:pt>
                <c:pt idx="19">
                  <c:v>Bb20</c:v>
                </c:pt>
                <c:pt idx="20">
                  <c:v>Bb21</c:v>
                </c:pt>
                <c:pt idx="21">
                  <c:v>Bb22</c:v>
                </c:pt>
                <c:pt idx="22">
                  <c:v>Bb23</c:v>
                </c:pt>
                <c:pt idx="23">
                  <c:v>Bb24</c:v>
                </c:pt>
                <c:pt idx="24">
                  <c:v>Bb25</c:v>
                </c:pt>
                <c:pt idx="25">
                  <c:v>Bb26</c:v>
                </c:pt>
                <c:pt idx="26">
                  <c:v>Bb27</c:v>
                </c:pt>
                <c:pt idx="27">
                  <c:v>Bb28</c:v>
                </c:pt>
                <c:pt idx="28">
                  <c:v>Bb29</c:v>
                </c:pt>
                <c:pt idx="29">
                  <c:v>Bb30</c:v>
                </c:pt>
                <c:pt idx="30">
                  <c:v>Beveroz</c:v>
                </c:pt>
              </c:strCache>
            </c:strRef>
          </c:cat>
          <c:val>
            <c:numRef>
              <c:f>Sheet1!$G$6:$G$36</c:f>
              <c:numCache>
                <c:formatCode>General</c:formatCode>
                <c:ptCount val="31"/>
                <c:pt idx="0">
                  <c:v>70.7</c:v>
                </c:pt>
                <c:pt idx="1">
                  <c:v>56.49</c:v>
                </c:pt>
                <c:pt idx="2">
                  <c:v>65.260000000000005</c:v>
                </c:pt>
                <c:pt idx="3">
                  <c:v>28.130000000000031</c:v>
                </c:pt>
                <c:pt idx="4">
                  <c:v>11.93</c:v>
                </c:pt>
                <c:pt idx="5">
                  <c:v>97.78</c:v>
                </c:pt>
                <c:pt idx="6">
                  <c:v>74.849999999999994</c:v>
                </c:pt>
                <c:pt idx="7">
                  <c:v>6.49</c:v>
                </c:pt>
                <c:pt idx="8">
                  <c:v>67.31</c:v>
                </c:pt>
                <c:pt idx="9">
                  <c:v>34.74</c:v>
                </c:pt>
                <c:pt idx="10">
                  <c:v>41.35</c:v>
                </c:pt>
                <c:pt idx="11">
                  <c:v>94.5</c:v>
                </c:pt>
                <c:pt idx="12">
                  <c:v>77.08</c:v>
                </c:pt>
                <c:pt idx="13">
                  <c:v>23.86</c:v>
                </c:pt>
                <c:pt idx="14">
                  <c:v>96.73</c:v>
                </c:pt>
                <c:pt idx="15">
                  <c:v>32.57</c:v>
                </c:pt>
                <c:pt idx="16">
                  <c:v>70.64</c:v>
                </c:pt>
                <c:pt idx="17">
                  <c:v>31.4</c:v>
                </c:pt>
                <c:pt idx="18">
                  <c:v>69.59</c:v>
                </c:pt>
                <c:pt idx="19">
                  <c:v>76.02</c:v>
                </c:pt>
                <c:pt idx="20">
                  <c:v>26.37</c:v>
                </c:pt>
                <c:pt idx="21">
                  <c:v>35.85</c:v>
                </c:pt>
                <c:pt idx="22">
                  <c:v>24.97</c:v>
                </c:pt>
                <c:pt idx="23">
                  <c:v>89.11999999999999</c:v>
                </c:pt>
                <c:pt idx="24">
                  <c:v>58.71</c:v>
                </c:pt>
                <c:pt idx="25">
                  <c:v>88.01</c:v>
                </c:pt>
                <c:pt idx="26">
                  <c:v>83.63</c:v>
                </c:pt>
                <c:pt idx="27">
                  <c:v>83.679999999999978</c:v>
                </c:pt>
                <c:pt idx="28">
                  <c:v>77.13</c:v>
                </c:pt>
                <c:pt idx="29">
                  <c:v>85.910000000000025</c:v>
                </c:pt>
                <c:pt idx="30">
                  <c:v>74.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097-4504-ADBD-32A6906EB7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21623680"/>
        <c:axId val="222352032"/>
      </c:barChart>
      <c:catAx>
        <c:axId val="221623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22352032"/>
        <c:crosses val="autoZero"/>
        <c:auto val="1"/>
        <c:lblAlgn val="ctr"/>
        <c:lblOffset val="100"/>
        <c:noMultiLvlLbl val="0"/>
      </c:catAx>
      <c:valAx>
        <c:axId val="2223520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216236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IN" b="1" baseline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Mycosis (</a:t>
            </a:r>
            <a:r>
              <a:rPr lang="en-IN" sz="1400" b="1" i="0" u="none" strike="noStrike" baseline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%)</a:t>
            </a:r>
            <a:r>
              <a:rPr lang="en-IN" b="1" baseline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N" b="1" baseline="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sz="1400" b="1" i="1" u="none" strike="noStrike" baseline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. </a:t>
            </a:r>
            <a:r>
              <a:rPr lang="en-US" sz="1400" b="1" i="1" u="none" strike="noStrike" baseline="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truncatus</a:t>
            </a:r>
            <a:r>
              <a:rPr lang="en-US" sz="1400" b="1" i="1" u="none" strike="noStrike" baseline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en-US" sz="1400" b="1" i="0" u="none" strike="noStrike" baseline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aused by </a:t>
            </a:r>
            <a:r>
              <a:rPr lang="en-IN" b="1" i="1" baseline="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B </a:t>
            </a:r>
            <a:r>
              <a:rPr lang="en-IN" b="1" i="1" baseline="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bassiana</a:t>
            </a:r>
            <a:endParaRPr lang="en-IN" b="1" i="1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c:rich>
      </c:tx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C$5</c:f>
              <c:strCache>
                <c:ptCount val="1"/>
                <c:pt idx="0">
                  <c:v>5DAI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B$40:$B$70</c:f>
                <c:numCache>
                  <c:formatCode>General</c:formatCode>
                  <c:ptCount val="31"/>
                  <c:pt idx="0">
                    <c:v>1.48</c:v>
                  </c:pt>
                  <c:pt idx="1">
                    <c:v>2.4699999999999998</c:v>
                  </c:pt>
                  <c:pt idx="2">
                    <c:v>2.52</c:v>
                  </c:pt>
                  <c:pt idx="3">
                    <c:v>1.57</c:v>
                  </c:pt>
                  <c:pt idx="4">
                    <c:v>0</c:v>
                  </c:pt>
                  <c:pt idx="5">
                    <c:v>1.29</c:v>
                  </c:pt>
                  <c:pt idx="6">
                    <c:v>3.27</c:v>
                  </c:pt>
                  <c:pt idx="7">
                    <c:v>2.58</c:v>
                  </c:pt>
                  <c:pt idx="8">
                    <c:v>2.08</c:v>
                  </c:pt>
                  <c:pt idx="9">
                    <c:v>4.25</c:v>
                  </c:pt>
                  <c:pt idx="10">
                    <c:v>3.02</c:v>
                  </c:pt>
                  <c:pt idx="11">
                    <c:v>2.86</c:v>
                  </c:pt>
                  <c:pt idx="12">
                    <c:v>2.61</c:v>
                  </c:pt>
                  <c:pt idx="13">
                    <c:v>3.3699999999999997</c:v>
                  </c:pt>
                  <c:pt idx="14">
                    <c:v>4.71</c:v>
                  </c:pt>
                  <c:pt idx="15">
                    <c:v>3.8299999999999987</c:v>
                  </c:pt>
                  <c:pt idx="16">
                    <c:v>1.86</c:v>
                  </c:pt>
                  <c:pt idx="17">
                    <c:v>4.6399999999999997</c:v>
                  </c:pt>
                  <c:pt idx="18">
                    <c:v>2.3499999999999988</c:v>
                  </c:pt>
                  <c:pt idx="19">
                    <c:v>1.51</c:v>
                  </c:pt>
                  <c:pt idx="20">
                    <c:v>0</c:v>
                  </c:pt>
                  <c:pt idx="21">
                    <c:v>2.21</c:v>
                  </c:pt>
                  <c:pt idx="22">
                    <c:v>4.9400000000000004</c:v>
                  </c:pt>
                  <c:pt idx="23">
                    <c:v>2.04</c:v>
                  </c:pt>
                  <c:pt idx="24">
                    <c:v>2.1800000000000002</c:v>
                  </c:pt>
                  <c:pt idx="25">
                    <c:v>3.44</c:v>
                  </c:pt>
                  <c:pt idx="26">
                    <c:v>2.88</c:v>
                  </c:pt>
                  <c:pt idx="27">
                    <c:v>1.1200000000000001</c:v>
                  </c:pt>
                  <c:pt idx="28">
                    <c:v>2.98</c:v>
                  </c:pt>
                  <c:pt idx="29">
                    <c:v>1.8</c:v>
                  </c:pt>
                  <c:pt idx="30">
                    <c:v>3.17</c:v>
                  </c:pt>
                </c:numCache>
              </c:numRef>
            </c:plus>
            <c:minus>
              <c:numRef>
                <c:f>Sheet2!$B$40:$B$70</c:f>
                <c:numCache>
                  <c:formatCode>General</c:formatCode>
                  <c:ptCount val="31"/>
                  <c:pt idx="0">
                    <c:v>1.48</c:v>
                  </c:pt>
                  <c:pt idx="1">
                    <c:v>2.4699999999999998</c:v>
                  </c:pt>
                  <c:pt idx="2">
                    <c:v>2.52</c:v>
                  </c:pt>
                  <c:pt idx="3">
                    <c:v>1.57</c:v>
                  </c:pt>
                  <c:pt idx="4">
                    <c:v>0</c:v>
                  </c:pt>
                  <c:pt idx="5">
                    <c:v>1.29</c:v>
                  </c:pt>
                  <c:pt idx="6">
                    <c:v>3.27</c:v>
                  </c:pt>
                  <c:pt idx="7">
                    <c:v>2.58</c:v>
                  </c:pt>
                  <c:pt idx="8">
                    <c:v>2.08</c:v>
                  </c:pt>
                  <c:pt idx="9">
                    <c:v>4.25</c:v>
                  </c:pt>
                  <c:pt idx="10">
                    <c:v>3.02</c:v>
                  </c:pt>
                  <c:pt idx="11">
                    <c:v>2.86</c:v>
                  </c:pt>
                  <c:pt idx="12">
                    <c:v>2.61</c:v>
                  </c:pt>
                  <c:pt idx="13">
                    <c:v>3.3699999999999997</c:v>
                  </c:pt>
                  <c:pt idx="14">
                    <c:v>4.71</c:v>
                  </c:pt>
                  <c:pt idx="15">
                    <c:v>3.8299999999999987</c:v>
                  </c:pt>
                  <c:pt idx="16">
                    <c:v>1.86</c:v>
                  </c:pt>
                  <c:pt idx="17">
                    <c:v>4.6399999999999997</c:v>
                  </c:pt>
                  <c:pt idx="18">
                    <c:v>2.3499999999999988</c:v>
                  </c:pt>
                  <c:pt idx="19">
                    <c:v>1.51</c:v>
                  </c:pt>
                  <c:pt idx="20">
                    <c:v>0</c:v>
                  </c:pt>
                  <c:pt idx="21">
                    <c:v>2.21</c:v>
                  </c:pt>
                  <c:pt idx="22">
                    <c:v>4.9400000000000004</c:v>
                  </c:pt>
                  <c:pt idx="23">
                    <c:v>2.04</c:v>
                  </c:pt>
                  <c:pt idx="24">
                    <c:v>2.1800000000000002</c:v>
                  </c:pt>
                  <c:pt idx="25">
                    <c:v>3.44</c:v>
                  </c:pt>
                  <c:pt idx="26">
                    <c:v>2.88</c:v>
                  </c:pt>
                  <c:pt idx="27">
                    <c:v>1.1200000000000001</c:v>
                  </c:pt>
                  <c:pt idx="28">
                    <c:v>2.98</c:v>
                  </c:pt>
                  <c:pt idx="29">
                    <c:v>1.8</c:v>
                  </c:pt>
                  <c:pt idx="30">
                    <c:v>3.1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6:$B$36</c:f>
              <c:strCache>
                <c:ptCount val="31"/>
                <c:pt idx="0">
                  <c:v>Bb1</c:v>
                </c:pt>
                <c:pt idx="1">
                  <c:v>Bb2</c:v>
                </c:pt>
                <c:pt idx="2">
                  <c:v>Bb3</c:v>
                </c:pt>
                <c:pt idx="3">
                  <c:v>Bb4</c:v>
                </c:pt>
                <c:pt idx="4">
                  <c:v>Bb5</c:v>
                </c:pt>
                <c:pt idx="5">
                  <c:v>BB6</c:v>
                </c:pt>
                <c:pt idx="6">
                  <c:v>Bb7</c:v>
                </c:pt>
                <c:pt idx="7">
                  <c:v>Bb8</c:v>
                </c:pt>
                <c:pt idx="8">
                  <c:v>Bb9</c:v>
                </c:pt>
                <c:pt idx="9">
                  <c:v>Bb10</c:v>
                </c:pt>
                <c:pt idx="10">
                  <c:v>Bb11</c:v>
                </c:pt>
                <c:pt idx="11">
                  <c:v>Bb12</c:v>
                </c:pt>
                <c:pt idx="12">
                  <c:v>Bb13</c:v>
                </c:pt>
                <c:pt idx="13">
                  <c:v>Bb14</c:v>
                </c:pt>
                <c:pt idx="14">
                  <c:v>Bb15</c:v>
                </c:pt>
                <c:pt idx="15">
                  <c:v>Bb16</c:v>
                </c:pt>
                <c:pt idx="16">
                  <c:v>Bb17</c:v>
                </c:pt>
                <c:pt idx="17">
                  <c:v>Bb18</c:v>
                </c:pt>
                <c:pt idx="18">
                  <c:v>Bb19</c:v>
                </c:pt>
                <c:pt idx="19">
                  <c:v>Bb20</c:v>
                </c:pt>
                <c:pt idx="20">
                  <c:v>Bb21</c:v>
                </c:pt>
                <c:pt idx="21">
                  <c:v>Bb22</c:v>
                </c:pt>
                <c:pt idx="22">
                  <c:v>Bb23</c:v>
                </c:pt>
                <c:pt idx="23">
                  <c:v>Bb24</c:v>
                </c:pt>
                <c:pt idx="24">
                  <c:v>Bb25</c:v>
                </c:pt>
                <c:pt idx="25">
                  <c:v>Bb26</c:v>
                </c:pt>
                <c:pt idx="26">
                  <c:v>Bb27</c:v>
                </c:pt>
                <c:pt idx="27">
                  <c:v>Bb28</c:v>
                </c:pt>
                <c:pt idx="28">
                  <c:v>Bb29</c:v>
                </c:pt>
                <c:pt idx="29">
                  <c:v>Bb30 </c:v>
                </c:pt>
                <c:pt idx="30">
                  <c:v>Beveroz</c:v>
                </c:pt>
              </c:strCache>
            </c:strRef>
          </c:cat>
          <c:val>
            <c:numRef>
              <c:f>Sheet2!$C$6:$C$36</c:f>
              <c:numCache>
                <c:formatCode>General</c:formatCode>
                <c:ptCount val="31"/>
                <c:pt idx="0">
                  <c:v>43</c:v>
                </c:pt>
                <c:pt idx="1">
                  <c:v>15</c:v>
                </c:pt>
                <c:pt idx="2">
                  <c:v>44</c:v>
                </c:pt>
                <c:pt idx="3">
                  <c:v>10</c:v>
                </c:pt>
                <c:pt idx="4">
                  <c:v>0</c:v>
                </c:pt>
                <c:pt idx="5">
                  <c:v>85</c:v>
                </c:pt>
                <c:pt idx="6">
                  <c:v>36</c:v>
                </c:pt>
                <c:pt idx="7">
                  <c:v>1</c:v>
                </c:pt>
                <c:pt idx="8">
                  <c:v>32</c:v>
                </c:pt>
                <c:pt idx="9">
                  <c:v>9</c:v>
                </c:pt>
                <c:pt idx="10">
                  <c:v>25</c:v>
                </c:pt>
                <c:pt idx="11">
                  <c:v>84</c:v>
                </c:pt>
                <c:pt idx="12">
                  <c:v>63</c:v>
                </c:pt>
                <c:pt idx="13">
                  <c:v>6</c:v>
                </c:pt>
                <c:pt idx="14">
                  <c:v>88</c:v>
                </c:pt>
                <c:pt idx="15">
                  <c:v>7</c:v>
                </c:pt>
                <c:pt idx="16">
                  <c:v>60</c:v>
                </c:pt>
                <c:pt idx="17">
                  <c:v>4</c:v>
                </c:pt>
                <c:pt idx="18">
                  <c:v>41</c:v>
                </c:pt>
                <c:pt idx="19">
                  <c:v>63</c:v>
                </c:pt>
                <c:pt idx="20">
                  <c:v>0</c:v>
                </c:pt>
                <c:pt idx="21">
                  <c:v>10</c:v>
                </c:pt>
                <c:pt idx="22">
                  <c:v>7</c:v>
                </c:pt>
                <c:pt idx="23">
                  <c:v>68</c:v>
                </c:pt>
                <c:pt idx="24">
                  <c:v>11</c:v>
                </c:pt>
                <c:pt idx="25">
                  <c:v>73</c:v>
                </c:pt>
                <c:pt idx="26">
                  <c:v>67</c:v>
                </c:pt>
                <c:pt idx="27">
                  <c:v>64</c:v>
                </c:pt>
                <c:pt idx="28">
                  <c:v>54</c:v>
                </c:pt>
                <c:pt idx="29">
                  <c:v>69</c:v>
                </c:pt>
                <c:pt idx="30">
                  <c:v>3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D0E-45F2-8BAB-7B8789EA74B3}"/>
            </c:ext>
          </c:extLst>
        </c:ser>
        <c:ser>
          <c:idx val="1"/>
          <c:order val="1"/>
          <c:tx>
            <c:strRef>
              <c:f>Sheet2!$D$5</c:f>
              <c:strCache>
                <c:ptCount val="1"/>
                <c:pt idx="0">
                  <c:v>8 DAI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2!$C$40:$C$70</c:f>
                <c:numCache>
                  <c:formatCode>General</c:formatCode>
                  <c:ptCount val="31"/>
                  <c:pt idx="0">
                    <c:v>1.58</c:v>
                  </c:pt>
                  <c:pt idx="1">
                    <c:v>1.9600000000000026</c:v>
                  </c:pt>
                  <c:pt idx="2">
                    <c:v>1.47</c:v>
                  </c:pt>
                  <c:pt idx="3">
                    <c:v>1.29</c:v>
                  </c:pt>
                  <c:pt idx="4">
                    <c:v>0</c:v>
                  </c:pt>
                  <c:pt idx="5">
                    <c:v>1.9500000000000026</c:v>
                  </c:pt>
                  <c:pt idx="6">
                    <c:v>2.16</c:v>
                  </c:pt>
                  <c:pt idx="7">
                    <c:v>2.58</c:v>
                  </c:pt>
                  <c:pt idx="8">
                    <c:v>1.48</c:v>
                  </c:pt>
                  <c:pt idx="9">
                    <c:v>2.61</c:v>
                  </c:pt>
                  <c:pt idx="10">
                    <c:v>2.1</c:v>
                  </c:pt>
                  <c:pt idx="11">
                    <c:v>2.5</c:v>
                  </c:pt>
                  <c:pt idx="12">
                    <c:v>2.2200000000000002</c:v>
                  </c:pt>
                  <c:pt idx="13">
                    <c:v>1.82</c:v>
                  </c:pt>
                  <c:pt idx="14">
                    <c:v>4.71</c:v>
                  </c:pt>
                  <c:pt idx="15">
                    <c:v>4.57</c:v>
                  </c:pt>
                  <c:pt idx="16">
                    <c:v>2.56</c:v>
                  </c:pt>
                  <c:pt idx="17">
                    <c:v>5.6599999999999975</c:v>
                  </c:pt>
                  <c:pt idx="18">
                    <c:v>2.13</c:v>
                  </c:pt>
                  <c:pt idx="19">
                    <c:v>1.74</c:v>
                  </c:pt>
                  <c:pt idx="20">
                    <c:v>4.3599999999999985</c:v>
                  </c:pt>
                  <c:pt idx="21">
                    <c:v>2.2999999999999998</c:v>
                  </c:pt>
                  <c:pt idx="22">
                    <c:v>4.9400000000000004</c:v>
                  </c:pt>
                  <c:pt idx="23">
                    <c:v>1.77</c:v>
                  </c:pt>
                  <c:pt idx="24">
                    <c:v>1.33</c:v>
                  </c:pt>
                  <c:pt idx="25">
                    <c:v>2.3499999999999988</c:v>
                  </c:pt>
                  <c:pt idx="26">
                    <c:v>1.78</c:v>
                  </c:pt>
                  <c:pt idx="27">
                    <c:v>1.8800000000000001</c:v>
                  </c:pt>
                  <c:pt idx="28">
                    <c:v>1.47</c:v>
                  </c:pt>
                  <c:pt idx="29">
                    <c:v>2.92</c:v>
                  </c:pt>
                  <c:pt idx="30">
                    <c:v>2.15</c:v>
                  </c:pt>
                </c:numCache>
              </c:numRef>
            </c:plus>
            <c:minus>
              <c:numRef>
                <c:f>Sheet2!$C$40:$C$70</c:f>
                <c:numCache>
                  <c:formatCode>General</c:formatCode>
                  <c:ptCount val="31"/>
                  <c:pt idx="0">
                    <c:v>1.58</c:v>
                  </c:pt>
                  <c:pt idx="1">
                    <c:v>1.9600000000000026</c:v>
                  </c:pt>
                  <c:pt idx="2">
                    <c:v>1.47</c:v>
                  </c:pt>
                  <c:pt idx="3">
                    <c:v>1.29</c:v>
                  </c:pt>
                  <c:pt idx="4">
                    <c:v>0</c:v>
                  </c:pt>
                  <c:pt idx="5">
                    <c:v>1.9500000000000026</c:v>
                  </c:pt>
                  <c:pt idx="6">
                    <c:v>2.16</c:v>
                  </c:pt>
                  <c:pt idx="7">
                    <c:v>2.58</c:v>
                  </c:pt>
                  <c:pt idx="8">
                    <c:v>1.48</c:v>
                  </c:pt>
                  <c:pt idx="9">
                    <c:v>2.61</c:v>
                  </c:pt>
                  <c:pt idx="10">
                    <c:v>2.1</c:v>
                  </c:pt>
                  <c:pt idx="11">
                    <c:v>2.5</c:v>
                  </c:pt>
                  <c:pt idx="12">
                    <c:v>2.2200000000000002</c:v>
                  </c:pt>
                  <c:pt idx="13">
                    <c:v>1.82</c:v>
                  </c:pt>
                  <c:pt idx="14">
                    <c:v>4.71</c:v>
                  </c:pt>
                  <c:pt idx="15">
                    <c:v>4.57</c:v>
                  </c:pt>
                  <c:pt idx="16">
                    <c:v>2.56</c:v>
                  </c:pt>
                  <c:pt idx="17">
                    <c:v>5.6599999999999975</c:v>
                  </c:pt>
                  <c:pt idx="18">
                    <c:v>2.13</c:v>
                  </c:pt>
                  <c:pt idx="19">
                    <c:v>1.74</c:v>
                  </c:pt>
                  <c:pt idx="20">
                    <c:v>4.3599999999999985</c:v>
                  </c:pt>
                  <c:pt idx="21">
                    <c:v>2.2999999999999998</c:v>
                  </c:pt>
                  <c:pt idx="22">
                    <c:v>4.9400000000000004</c:v>
                  </c:pt>
                  <c:pt idx="23">
                    <c:v>1.77</c:v>
                  </c:pt>
                  <c:pt idx="24">
                    <c:v>1.33</c:v>
                  </c:pt>
                  <c:pt idx="25">
                    <c:v>2.3499999999999988</c:v>
                  </c:pt>
                  <c:pt idx="26">
                    <c:v>1.78</c:v>
                  </c:pt>
                  <c:pt idx="27">
                    <c:v>1.8800000000000001</c:v>
                  </c:pt>
                  <c:pt idx="28">
                    <c:v>1.47</c:v>
                  </c:pt>
                  <c:pt idx="29">
                    <c:v>2.92</c:v>
                  </c:pt>
                  <c:pt idx="30">
                    <c:v>2.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2!$B$6:$B$36</c:f>
              <c:strCache>
                <c:ptCount val="31"/>
                <c:pt idx="0">
                  <c:v>Bb1</c:v>
                </c:pt>
                <c:pt idx="1">
                  <c:v>Bb2</c:v>
                </c:pt>
                <c:pt idx="2">
                  <c:v>Bb3</c:v>
                </c:pt>
                <c:pt idx="3">
                  <c:v>Bb4</c:v>
                </c:pt>
                <c:pt idx="4">
                  <c:v>Bb5</c:v>
                </c:pt>
                <c:pt idx="5">
                  <c:v>BB6</c:v>
                </c:pt>
                <c:pt idx="6">
                  <c:v>Bb7</c:v>
                </c:pt>
                <c:pt idx="7">
                  <c:v>Bb8</c:v>
                </c:pt>
                <c:pt idx="8">
                  <c:v>Bb9</c:v>
                </c:pt>
                <c:pt idx="9">
                  <c:v>Bb10</c:v>
                </c:pt>
                <c:pt idx="10">
                  <c:v>Bb11</c:v>
                </c:pt>
                <c:pt idx="11">
                  <c:v>Bb12</c:v>
                </c:pt>
                <c:pt idx="12">
                  <c:v>Bb13</c:v>
                </c:pt>
                <c:pt idx="13">
                  <c:v>Bb14</c:v>
                </c:pt>
                <c:pt idx="14">
                  <c:v>Bb15</c:v>
                </c:pt>
                <c:pt idx="15">
                  <c:v>Bb16</c:v>
                </c:pt>
                <c:pt idx="16">
                  <c:v>Bb17</c:v>
                </c:pt>
                <c:pt idx="17">
                  <c:v>Bb18</c:v>
                </c:pt>
                <c:pt idx="18">
                  <c:v>Bb19</c:v>
                </c:pt>
                <c:pt idx="19">
                  <c:v>Bb20</c:v>
                </c:pt>
                <c:pt idx="20">
                  <c:v>Bb21</c:v>
                </c:pt>
                <c:pt idx="21">
                  <c:v>Bb22</c:v>
                </c:pt>
                <c:pt idx="22">
                  <c:v>Bb23</c:v>
                </c:pt>
                <c:pt idx="23">
                  <c:v>Bb24</c:v>
                </c:pt>
                <c:pt idx="24">
                  <c:v>Bb25</c:v>
                </c:pt>
                <c:pt idx="25">
                  <c:v>Bb26</c:v>
                </c:pt>
                <c:pt idx="26">
                  <c:v>Bb27</c:v>
                </c:pt>
                <c:pt idx="27">
                  <c:v>Bb28</c:v>
                </c:pt>
                <c:pt idx="28">
                  <c:v>Bb29</c:v>
                </c:pt>
                <c:pt idx="29">
                  <c:v>Bb30 </c:v>
                </c:pt>
                <c:pt idx="30">
                  <c:v>Beveroz</c:v>
                </c:pt>
              </c:strCache>
            </c:strRef>
          </c:cat>
          <c:val>
            <c:numRef>
              <c:f>Sheet2!$D$6:$D$36</c:f>
              <c:numCache>
                <c:formatCode>General</c:formatCode>
                <c:ptCount val="31"/>
                <c:pt idx="0">
                  <c:v>50</c:v>
                </c:pt>
                <c:pt idx="1">
                  <c:v>17</c:v>
                </c:pt>
                <c:pt idx="2">
                  <c:v>52</c:v>
                </c:pt>
                <c:pt idx="3">
                  <c:v>15</c:v>
                </c:pt>
                <c:pt idx="4">
                  <c:v>0</c:v>
                </c:pt>
                <c:pt idx="5">
                  <c:v>88</c:v>
                </c:pt>
                <c:pt idx="6">
                  <c:v>53</c:v>
                </c:pt>
                <c:pt idx="7">
                  <c:v>1</c:v>
                </c:pt>
                <c:pt idx="8">
                  <c:v>42</c:v>
                </c:pt>
                <c:pt idx="9">
                  <c:v>14</c:v>
                </c:pt>
                <c:pt idx="10">
                  <c:v>31</c:v>
                </c:pt>
                <c:pt idx="11">
                  <c:v>85</c:v>
                </c:pt>
                <c:pt idx="12">
                  <c:v>69</c:v>
                </c:pt>
                <c:pt idx="13">
                  <c:v>11</c:v>
                </c:pt>
                <c:pt idx="14">
                  <c:v>88</c:v>
                </c:pt>
                <c:pt idx="15">
                  <c:v>11</c:v>
                </c:pt>
                <c:pt idx="16">
                  <c:v>68</c:v>
                </c:pt>
                <c:pt idx="17">
                  <c:v>6</c:v>
                </c:pt>
                <c:pt idx="18">
                  <c:v>51</c:v>
                </c:pt>
                <c:pt idx="19">
                  <c:v>66</c:v>
                </c:pt>
                <c:pt idx="20">
                  <c:v>5</c:v>
                </c:pt>
                <c:pt idx="21">
                  <c:v>12</c:v>
                </c:pt>
                <c:pt idx="22">
                  <c:v>7</c:v>
                </c:pt>
                <c:pt idx="23">
                  <c:v>81</c:v>
                </c:pt>
                <c:pt idx="24">
                  <c:v>23</c:v>
                </c:pt>
                <c:pt idx="25">
                  <c:v>78</c:v>
                </c:pt>
                <c:pt idx="26">
                  <c:v>77</c:v>
                </c:pt>
                <c:pt idx="27">
                  <c:v>71</c:v>
                </c:pt>
                <c:pt idx="28">
                  <c:v>64</c:v>
                </c:pt>
                <c:pt idx="29">
                  <c:v>76</c:v>
                </c:pt>
                <c:pt idx="30">
                  <c:v>5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D0E-45F2-8BAB-7B8789EA74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53"/>
        <c:overlap val="-30"/>
        <c:axId val="222348896"/>
        <c:axId val="222353208"/>
      </c:barChart>
      <c:catAx>
        <c:axId val="222348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22353208"/>
        <c:crosses val="autoZero"/>
        <c:auto val="1"/>
        <c:lblAlgn val="ctr"/>
        <c:lblOffset val="100"/>
        <c:noMultiLvlLbl val="0"/>
      </c:catAx>
      <c:valAx>
        <c:axId val="2223532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223488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endParaRPr lang="en-US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endParaRPr lang="en-US"/>
          </a:p>
        </c:txPr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7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26" Type="http://schemas.openxmlformats.org/officeDocument/2006/relationships/image" Target="../media/image25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29" Type="http://schemas.openxmlformats.org/officeDocument/2006/relationships/image" Target="../media/image2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28" Type="http://schemas.openxmlformats.org/officeDocument/2006/relationships/image" Target="../media/image27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31" Type="http://schemas.openxmlformats.org/officeDocument/2006/relationships/image" Target="../media/image30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Relationship Id="rId30" Type="http://schemas.openxmlformats.org/officeDocument/2006/relationships/image" Target="../media/image29.jpe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jpeg"/><Relationship Id="rId13" Type="http://schemas.openxmlformats.org/officeDocument/2006/relationships/image" Target="../media/image42.jpeg"/><Relationship Id="rId18" Type="http://schemas.openxmlformats.org/officeDocument/2006/relationships/image" Target="../media/image47.jpeg"/><Relationship Id="rId26" Type="http://schemas.openxmlformats.org/officeDocument/2006/relationships/image" Target="../media/image55.jpeg"/><Relationship Id="rId3" Type="http://schemas.openxmlformats.org/officeDocument/2006/relationships/image" Target="../media/image32.jpeg"/><Relationship Id="rId21" Type="http://schemas.openxmlformats.org/officeDocument/2006/relationships/image" Target="../media/image50.jpeg"/><Relationship Id="rId7" Type="http://schemas.openxmlformats.org/officeDocument/2006/relationships/image" Target="../media/image36.jpeg"/><Relationship Id="rId12" Type="http://schemas.openxmlformats.org/officeDocument/2006/relationships/image" Target="../media/image41.jpeg"/><Relationship Id="rId17" Type="http://schemas.openxmlformats.org/officeDocument/2006/relationships/image" Target="../media/image46.jpeg"/><Relationship Id="rId25" Type="http://schemas.openxmlformats.org/officeDocument/2006/relationships/image" Target="../media/image54.jpeg"/><Relationship Id="rId2" Type="http://schemas.openxmlformats.org/officeDocument/2006/relationships/image" Target="../media/image31.jpeg"/><Relationship Id="rId16" Type="http://schemas.openxmlformats.org/officeDocument/2006/relationships/image" Target="../media/image45.jpeg"/><Relationship Id="rId20" Type="http://schemas.openxmlformats.org/officeDocument/2006/relationships/image" Target="../media/image49.jpeg"/><Relationship Id="rId29" Type="http://schemas.openxmlformats.org/officeDocument/2006/relationships/image" Target="../media/image5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jpeg"/><Relationship Id="rId11" Type="http://schemas.openxmlformats.org/officeDocument/2006/relationships/image" Target="../media/image40.jpeg"/><Relationship Id="rId24" Type="http://schemas.openxmlformats.org/officeDocument/2006/relationships/image" Target="../media/image53.jpeg"/><Relationship Id="rId5" Type="http://schemas.openxmlformats.org/officeDocument/2006/relationships/image" Target="../media/image34.jpeg"/><Relationship Id="rId15" Type="http://schemas.openxmlformats.org/officeDocument/2006/relationships/image" Target="../media/image44.jpeg"/><Relationship Id="rId23" Type="http://schemas.openxmlformats.org/officeDocument/2006/relationships/image" Target="../media/image52.jpeg"/><Relationship Id="rId28" Type="http://schemas.openxmlformats.org/officeDocument/2006/relationships/image" Target="../media/image57.jpeg"/><Relationship Id="rId10" Type="http://schemas.openxmlformats.org/officeDocument/2006/relationships/image" Target="../media/image39.jpeg"/><Relationship Id="rId19" Type="http://schemas.openxmlformats.org/officeDocument/2006/relationships/image" Target="../media/image48.jpeg"/><Relationship Id="rId31" Type="http://schemas.openxmlformats.org/officeDocument/2006/relationships/image" Target="../media/image60.jpeg"/><Relationship Id="rId4" Type="http://schemas.openxmlformats.org/officeDocument/2006/relationships/image" Target="../media/image33.jpeg"/><Relationship Id="rId9" Type="http://schemas.openxmlformats.org/officeDocument/2006/relationships/image" Target="../media/image38.jpeg"/><Relationship Id="rId14" Type="http://schemas.openxmlformats.org/officeDocument/2006/relationships/image" Target="../media/image43.jpeg"/><Relationship Id="rId22" Type="http://schemas.openxmlformats.org/officeDocument/2006/relationships/image" Target="../media/image51.jpeg"/><Relationship Id="rId27" Type="http://schemas.openxmlformats.org/officeDocument/2006/relationships/image" Target="../media/image56.jpeg"/><Relationship Id="rId30" Type="http://schemas.openxmlformats.org/officeDocument/2006/relationships/image" Target="../media/image59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jpeg"/><Relationship Id="rId13" Type="http://schemas.openxmlformats.org/officeDocument/2006/relationships/image" Target="../media/image72.jpeg"/><Relationship Id="rId18" Type="http://schemas.openxmlformats.org/officeDocument/2006/relationships/image" Target="../media/image77.jpeg"/><Relationship Id="rId26" Type="http://schemas.openxmlformats.org/officeDocument/2006/relationships/image" Target="../media/image85.jpeg"/><Relationship Id="rId3" Type="http://schemas.openxmlformats.org/officeDocument/2006/relationships/image" Target="../media/image62.jpeg"/><Relationship Id="rId21" Type="http://schemas.openxmlformats.org/officeDocument/2006/relationships/image" Target="../media/image80.jpeg"/><Relationship Id="rId7" Type="http://schemas.openxmlformats.org/officeDocument/2006/relationships/image" Target="../media/image66.jpeg"/><Relationship Id="rId12" Type="http://schemas.openxmlformats.org/officeDocument/2006/relationships/image" Target="../media/image71.jpeg"/><Relationship Id="rId17" Type="http://schemas.openxmlformats.org/officeDocument/2006/relationships/image" Target="../media/image76.jpeg"/><Relationship Id="rId25" Type="http://schemas.openxmlformats.org/officeDocument/2006/relationships/image" Target="../media/image84.jpeg"/><Relationship Id="rId2" Type="http://schemas.openxmlformats.org/officeDocument/2006/relationships/image" Target="../media/image61.jpeg"/><Relationship Id="rId16" Type="http://schemas.openxmlformats.org/officeDocument/2006/relationships/image" Target="../media/image75.jpeg"/><Relationship Id="rId20" Type="http://schemas.openxmlformats.org/officeDocument/2006/relationships/image" Target="../media/image79.jpeg"/><Relationship Id="rId29" Type="http://schemas.openxmlformats.org/officeDocument/2006/relationships/image" Target="../media/image88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5.jpeg"/><Relationship Id="rId11" Type="http://schemas.openxmlformats.org/officeDocument/2006/relationships/image" Target="../media/image70.jpeg"/><Relationship Id="rId24" Type="http://schemas.openxmlformats.org/officeDocument/2006/relationships/image" Target="../media/image83.jpeg"/><Relationship Id="rId5" Type="http://schemas.openxmlformats.org/officeDocument/2006/relationships/image" Target="../media/image64.jpeg"/><Relationship Id="rId15" Type="http://schemas.openxmlformats.org/officeDocument/2006/relationships/image" Target="../media/image74.jpeg"/><Relationship Id="rId23" Type="http://schemas.openxmlformats.org/officeDocument/2006/relationships/image" Target="../media/image82.jpeg"/><Relationship Id="rId28" Type="http://schemas.openxmlformats.org/officeDocument/2006/relationships/image" Target="../media/image87.jpeg"/><Relationship Id="rId10" Type="http://schemas.openxmlformats.org/officeDocument/2006/relationships/image" Target="../media/image69.jpeg"/><Relationship Id="rId19" Type="http://schemas.openxmlformats.org/officeDocument/2006/relationships/image" Target="../media/image78.jpeg"/><Relationship Id="rId31" Type="http://schemas.openxmlformats.org/officeDocument/2006/relationships/image" Target="../media/image90.jpeg"/><Relationship Id="rId4" Type="http://schemas.openxmlformats.org/officeDocument/2006/relationships/image" Target="../media/image63.jpeg"/><Relationship Id="rId9" Type="http://schemas.openxmlformats.org/officeDocument/2006/relationships/image" Target="../media/image68.jpeg"/><Relationship Id="rId14" Type="http://schemas.openxmlformats.org/officeDocument/2006/relationships/image" Target="../media/image73.jpeg"/><Relationship Id="rId22" Type="http://schemas.openxmlformats.org/officeDocument/2006/relationships/image" Target="../media/image81.jpeg"/><Relationship Id="rId27" Type="http://schemas.openxmlformats.org/officeDocument/2006/relationships/image" Target="../media/image86.jpeg"/><Relationship Id="rId30" Type="http://schemas.openxmlformats.org/officeDocument/2006/relationships/image" Target="../media/image89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2.jpeg"/><Relationship Id="rId2" Type="http://schemas.openxmlformats.org/officeDocument/2006/relationships/image" Target="../media/image91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4.jpeg"/><Relationship Id="rId2" Type="http://schemas.openxmlformats.org/officeDocument/2006/relationships/image" Target="../media/image93.jpe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6.jpeg"/><Relationship Id="rId2" Type="http://schemas.openxmlformats.org/officeDocument/2006/relationships/image" Target="../media/image95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97"/>
          <p:cNvGrpSpPr/>
          <p:nvPr/>
        </p:nvGrpSpPr>
        <p:grpSpPr>
          <a:xfrm>
            <a:off x="1066800" y="381000"/>
            <a:ext cx="7543800" cy="5410200"/>
            <a:chOff x="533400" y="685800"/>
            <a:chExt cx="7162801" cy="5638800"/>
          </a:xfrm>
        </p:grpSpPr>
        <p:pic>
          <p:nvPicPr>
            <p:cNvPr id="7170" name="Picture 2" descr="F:\chaithra education documents\IARI education\research work\PhD research photos\4513\4513\IMG_20201014_113212 final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609600" y="685800"/>
              <a:ext cx="1143000" cy="1195470"/>
            </a:xfrm>
            <a:prstGeom prst="rect">
              <a:avLst/>
            </a:prstGeom>
            <a:noFill/>
          </p:spPr>
        </p:pic>
        <p:pic>
          <p:nvPicPr>
            <p:cNvPr id="7171" name="Picture 3" descr="F:\chaithra education documents\IARI education\research work\PhD research photos\4563\4563\IMG_20201031_110050 final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752600" y="685800"/>
              <a:ext cx="1219200" cy="1143000"/>
            </a:xfrm>
            <a:prstGeom prst="rect">
              <a:avLst/>
            </a:prstGeom>
            <a:noFill/>
          </p:spPr>
        </p:pic>
        <p:pic>
          <p:nvPicPr>
            <p:cNvPr id="7172" name="Picture 4" descr="F:\chaithra education documents\IARI education\research work\PhD research photos\6527\6527\IMG_20201026_121904 final (1)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971800" y="685800"/>
              <a:ext cx="1241127" cy="1143000"/>
            </a:xfrm>
            <a:prstGeom prst="rect">
              <a:avLst/>
            </a:prstGeom>
            <a:noFill/>
          </p:spPr>
        </p:pic>
        <p:pic>
          <p:nvPicPr>
            <p:cNvPr id="7173" name="Picture 5" descr="F:\chaithra education documents\IARI education\research work\PhD research photos\7130\7130\P1019482 final (2).JP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191000" y="685800"/>
              <a:ext cx="1219200" cy="1143000"/>
            </a:xfrm>
            <a:prstGeom prst="rect">
              <a:avLst/>
            </a:prstGeom>
            <a:noFill/>
          </p:spPr>
        </p:pic>
        <p:pic>
          <p:nvPicPr>
            <p:cNvPr id="7175" name="Picture 7" descr="F:\chaithra education documents\IARI education\research work\PhD research photos\4668\4668\IMG_20201031_110005 final.jp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5410200" y="685800"/>
              <a:ext cx="1143000" cy="1143000"/>
            </a:xfrm>
            <a:prstGeom prst="rect">
              <a:avLst/>
            </a:prstGeom>
            <a:noFill/>
          </p:spPr>
        </p:pic>
        <p:pic>
          <p:nvPicPr>
            <p:cNvPr id="7176" name="Picture 8" descr="F:\chaithra education documents\IARI education\research work\PhD research photos\5408\5408\IMG_20201031_110028 final.jp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6553200" y="685800"/>
              <a:ext cx="1143000" cy="1143000"/>
            </a:xfrm>
            <a:prstGeom prst="rect">
              <a:avLst/>
            </a:prstGeom>
            <a:noFill/>
          </p:spPr>
        </p:pic>
        <p:sp>
          <p:nvSpPr>
            <p:cNvPr id="11" name="TextBox 10"/>
            <p:cNvSpPr txBox="1"/>
            <p:nvPr/>
          </p:nvSpPr>
          <p:spPr>
            <a:xfrm>
              <a:off x="533400" y="685801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pic>
          <p:nvPicPr>
            <p:cNvPr id="7177" name="Picture 9" descr="F:\chaithra education documents\IARI education\research work\PhD research photos\5409\5409\IMG_20201014_113327 final (1).jp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609600" y="1828800"/>
              <a:ext cx="1143000" cy="1066800"/>
            </a:xfrm>
            <a:prstGeom prst="rect">
              <a:avLst/>
            </a:prstGeom>
            <a:noFill/>
          </p:spPr>
        </p:pic>
        <p:pic>
          <p:nvPicPr>
            <p:cNvPr id="7178" name="Picture 10" descr="F:\chaithra education documents\IARI education\research work\PhD research photos\7127\7127\IMG_20201009_110723.jp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1752600" y="1828800"/>
              <a:ext cx="1219200" cy="1066800"/>
            </a:xfrm>
            <a:prstGeom prst="rect">
              <a:avLst/>
            </a:prstGeom>
            <a:noFill/>
          </p:spPr>
        </p:pic>
        <p:pic>
          <p:nvPicPr>
            <p:cNvPr id="7179" name="Picture 11" descr="F:\chaithra education documents\IARI education\research work\PhD research photos\7128\7128\IMG_20201031_105836 final (1).jpg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2971800" y="1828800"/>
              <a:ext cx="1219199" cy="1066800"/>
            </a:xfrm>
            <a:prstGeom prst="rect">
              <a:avLst/>
            </a:prstGeom>
            <a:noFill/>
          </p:spPr>
        </p:pic>
        <p:pic>
          <p:nvPicPr>
            <p:cNvPr id="7180" name="Picture 12" descr="F:\chaithra education documents\IARI education\research work\PhD research photos\4703\4703\IMG_20201014_114013 final.jpg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4191000" y="1828801"/>
              <a:ext cx="1219200" cy="1066800"/>
            </a:xfrm>
            <a:prstGeom prst="rect">
              <a:avLst/>
            </a:prstGeom>
            <a:noFill/>
          </p:spPr>
        </p:pic>
        <p:pic>
          <p:nvPicPr>
            <p:cNvPr id="7181" name="Picture 13" descr="F:\chaithra education documents\IARI education\research work\PhD research photos\6645\6645\IMG_20201026_122304 final (1).jpg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5410200" y="1828800"/>
              <a:ext cx="1143000" cy="1085872"/>
            </a:xfrm>
            <a:prstGeom prst="rect">
              <a:avLst/>
            </a:prstGeom>
            <a:noFill/>
          </p:spPr>
        </p:pic>
        <p:pic>
          <p:nvPicPr>
            <p:cNvPr id="7182" name="Picture 14" descr="F:\chaithra education documents\IARI education\research work\PhD research photos\7042\7042\IMG_20201014_113511.jpg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6553200" y="1828800"/>
              <a:ext cx="1143000" cy="1066800"/>
            </a:xfrm>
            <a:prstGeom prst="rect">
              <a:avLst/>
            </a:prstGeom>
            <a:noFill/>
          </p:spPr>
        </p:pic>
        <p:pic>
          <p:nvPicPr>
            <p:cNvPr id="7183" name="Picture 15" descr="F:\chaithra education documents\IARI education\research work\PhD research photos\5549\5549\IMG_20201014_113936 final (1).jpg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609600" y="2895600"/>
              <a:ext cx="1143000" cy="1143000"/>
            </a:xfrm>
            <a:prstGeom prst="rect">
              <a:avLst/>
            </a:prstGeom>
            <a:noFill/>
          </p:spPr>
        </p:pic>
        <p:pic>
          <p:nvPicPr>
            <p:cNvPr id="7184" name="Picture 16" descr="F:\chaithra education documents\IARI education\research work\PhD research photos\6628\6628\IMG_20201014_113541 final (1).jpg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1752600" y="2895600"/>
              <a:ext cx="1219200" cy="1143000"/>
            </a:xfrm>
            <a:prstGeom prst="rect">
              <a:avLst/>
            </a:prstGeom>
            <a:noFill/>
          </p:spPr>
        </p:pic>
        <p:pic>
          <p:nvPicPr>
            <p:cNvPr id="7185" name="Picture 17" descr="F:\chaithra education documents\IARI education\research work\PhD research photos\7035\7035\IMG_20201014_113612 final.jpg"/>
            <p:cNvPicPr>
              <a:picLocks noChangeAspect="1"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2971799" y="2895600"/>
              <a:ext cx="1219893" cy="1143000"/>
            </a:xfrm>
            <a:prstGeom prst="rect">
              <a:avLst/>
            </a:prstGeom>
            <a:noFill/>
          </p:spPr>
        </p:pic>
        <p:pic>
          <p:nvPicPr>
            <p:cNvPr id="7186" name="Picture 18" descr="F:\chaithra education documents\IARI education\research work\PhD research photos\490\490\IMG_20201014_113704 final.jpg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4191000" y="2895599"/>
              <a:ext cx="1219200" cy="1143001"/>
            </a:xfrm>
            <a:prstGeom prst="rect">
              <a:avLst/>
            </a:prstGeom>
            <a:noFill/>
          </p:spPr>
        </p:pic>
        <p:pic>
          <p:nvPicPr>
            <p:cNvPr id="7187" name="Picture 19" descr="F:\chaithra education documents\IARI education\research work\PhD research photos\913\913\IMG_20201014_113754 final.jpg"/>
            <p:cNvPicPr>
              <a:picLocks noChangeAspect="1" noChangeArrowheads="1"/>
            </p:cNvPicPr>
            <p:nvPr/>
          </p:nvPicPr>
          <p:blipFill>
            <a:blip r:embed="rId18" cstate="print"/>
            <a:srcRect/>
            <a:stretch>
              <a:fillRect/>
            </a:stretch>
          </p:blipFill>
          <p:spPr bwMode="auto">
            <a:xfrm>
              <a:off x="5410200" y="2895600"/>
              <a:ext cx="1143000" cy="1143000"/>
            </a:xfrm>
            <a:prstGeom prst="rect">
              <a:avLst/>
            </a:prstGeom>
            <a:noFill/>
          </p:spPr>
        </p:pic>
        <p:pic>
          <p:nvPicPr>
            <p:cNvPr id="7188" name="Picture 20" descr="F:\chaithra education documents\IARI education\research work\PhD research photos\4925\4925\P1019216.JPG"/>
            <p:cNvPicPr>
              <a:picLocks noChangeAspect="1" noChangeArrowheads="1"/>
            </p:cNvPicPr>
            <p:nvPr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6553200" y="2895600"/>
              <a:ext cx="1143000" cy="1143000"/>
            </a:xfrm>
            <a:prstGeom prst="rect">
              <a:avLst/>
            </a:prstGeom>
            <a:noFill/>
          </p:spPr>
        </p:pic>
        <p:pic>
          <p:nvPicPr>
            <p:cNvPr id="7189" name="Picture 21" descr="F:\chaithra education documents\IARI education\research work\PhD research photos\5411\5411\IMG_20201014_113639 final (r) (2).jpg"/>
            <p:cNvPicPr>
              <a:picLocks noChangeAspect="1" noChangeArrowheads="1"/>
            </p:cNvPicPr>
            <p:nvPr/>
          </p:nvPicPr>
          <p:blipFill>
            <a:blip r:embed="rId20" cstate="print"/>
            <a:srcRect/>
            <a:stretch>
              <a:fillRect/>
            </a:stretch>
          </p:blipFill>
          <p:spPr bwMode="auto">
            <a:xfrm>
              <a:off x="609600" y="4038600"/>
              <a:ext cx="1143000" cy="1143000"/>
            </a:xfrm>
            <a:prstGeom prst="rect">
              <a:avLst/>
            </a:prstGeom>
            <a:noFill/>
          </p:spPr>
        </p:pic>
        <p:pic>
          <p:nvPicPr>
            <p:cNvPr id="7190" name="Picture 22" descr="F:\chaithra education documents\IARI education\research work\PhD research photos\5412\5412\IMG_20201009_111211.jpg"/>
            <p:cNvPicPr>
              <a:picLocks noChangeAspect="1" noChangeArrowheads="1"/>
            </p:cNvPicPr>
            <p:nvPr/>
          </p:nvPicPr>
          <p:blipFill>
            <a:blip r:embed="rId21" cstate="print"/>
            <a:srcRect/>
            <a:stretch>
              <a:fillRect/>
            </a:stretch>
          </p:blipFill>
          <p:spPr bwMode="auto">
            <a:xfrm>
              <a:off x="1752600" y="4038600"/>
              <a:ext cx="1219200" cy="1143000"/>
            </a:xfrm>
            <a:prstGeom prst="rect">
              <a:avLst/>
            </a:prstGeom>
            <a:noFill/>
          </p:spPr>
        </p:pic>
        <p:pic>
          <p:nvPicPr>
            <p:cNvPr id="7191" name="Picture 23" descr="F:\chaithra education documents\IARI education\research work\PhD research photos\6897\6897\IMG_20201031_105809 final (1).jpg"/>
            <p:cNvPicPr>
              <a:picLocks noChangeAspect="1" noChangeArrowheads="1"/>
            </p:cNvPicPr>
            <p:nvPr/>
          </p:nvPicPr>
          <p:blipFill>
            <a:blip r:embed="rId22" cstate="print"/>
            <a:srcRect/>
            <a:stretch>
              <a:fillRect/>
            </a:stretch>
          </p:blipFill>
          <p:spPr bwMode="auto">
            <a:xfrm>
              <a:off x="2971800" y="4038600"/>
              <a:ext cx="1219200" cy="1142999"/>
            </a:xfrm>
            <a:prstGeom prst="rect">
              <a:avLst/>
            </a:prstGeom>
            <a:noFill/>
          </p:spPr>
        </p:pic>
        <p:pic>
          <p:nvPicPr>
            <p:cNvPr id="7192" name="Picture 24" descr="F:\chaithra education documents\IARI education\research work\PhD research photos\6063\6063\IMG_20201026_122157 final (1).jpg"/>
            <p:cNvPicPr>
              <a:picLocks noChangeAspect="1" noChangeArrowheads="1"/>
            </p:cNvPicPr>
            <p:nvPr/>
          </p:nvPicPr>
          <p:blipFill>
            <a:blip r:embed="rId23" cstate="print"/>
            <a:srcRect/>
            <a:stretch>
              <a:fillRect/>
            </a:stretch>
          </p:blipFill>
          <p:spPr bwMode="auto">
            <a:xfrm>
              <a:off x="4191000" y="4038600"/>
              <a:ext cx="1219200" cy="1143000"/>
            </a:xfrm>
            <a:prstGeom prst="rect">
              <a:avLst/>
            </a:prstGeom>
            <a:noFill/>
          </p:spPr>
        </p:pic>
        <p:pic>
          <p:nvPicPr>
            <p:cNvPr id="7193" name="Picture 25" descr="F:\chaithra education documents\IARI education\research work\PhD research photos\6106\6106\IMG_20201014_113741 final (2).jpg"/>
            <p:cNvPicPr>
              <a:picLocks noChangeAspect="1" noChangeArrowheads="1"/>
            </p:cNvPicPr>
            <p:nvPr/>
          </p:nvPicPr>
          <p:blipFill>
            <a:blip r:embed="rId24" cstate="print"/>
            <a:srcRect/>
            <a:stretch>
              <a:fillRect/>
            </a:stretch>
          </p:blipFill>
          <p:spPr bwMode="auto">
            <a:xfrm>
              <a:off x="5410200" y="4038600"/>
              <a:ext cx="1143000" cy="1143000"/>
            </a:xfrm>
            <a:prstGeom prst="rect">
              <a:avLst/>
            </a:prstGeom>
            <a:noFill/>
          </p:spPr>
        </p:pic>
        <p:pic>
          <p:nvPicPr>
            <p:cNvPr id="7194" name="Picture 26" descr="F:\chaithra education documents\IARI education\research work\PhD research photos\5328\5328\IMG_20201014_113829 final.jpg"/>
            <p:cNvPicPr>
              <a:picLocks noChangeAspect="1" noChangeArrowheads="1"/>
            </p:cNvPicPr>
            <p:nvPr/>
          </p:nvPicPr>
          <p:blipFill>
            <a:blip r:embed="rId25" cstate="print"/>
            <a:srcRect/>
            <a:stretch>
              <a:fillRect/>
            </a:stretch>
          </p:blipFill>
          <p:spPr bwMode="auto">
            <a:xfrm>
              <a:off x="6553200" y="4038600"/>
              <a:ext cx="1143000" cy="1143000"/>
            </a:xfrm>
            <a:prstGeom prst="rect">
              <a:avLst/>
            </a:prstGeom>
            <a:noFill/>
          </p:spPr>
        </p:pic>
        <p:pic>
          <p:nvPicPr>
            <p:cNvPr id="7195" name="Picture 27" descr="F:\chaithra education documents\IARI education\research work\PhD research photos\7126\7126\IMG_20201014_113135 final (1).jpg"/>
            <p:cNvPicPr>
              <a:picLocks noChangeAspect="1" noChangeArrowheads="1"/>
            </p:cNvPicPr>
            <p:nvPr/>
          </p:nvPicPr>
          <p:blipFill>
            <a:blip r:embed="rId26" cstate="print"/>
            <a:srcRect/>
            <a:stretch>
              <a:fillRect/>
            </a:stretch>
          </p:blipFill>
          <p:spPr bwMode="auto">
            <a:xfrm>
              <a:off x="609600" y="5181600"/>
              <a:ext cx="1143000" cy="1143000"/>
            </a:xfrm>
            <a:prstGeom prst="rect">
              <a:avLst/>
            </a:prstGeom>
            <a:noFill/>
          </p:spPr>
        </p:pic>
        <p:pic>
          <p:nvPicPr>
            <p:cNvPr id="7197" name="Picture 29" descr="F:\chaithra education documents\IARI education\research work\PhD research photos\7102\7102\IMG_20201009_111244.jpg"/>
            <p:cNvPicPr>
              <a:picLocks noChangeAspect="1" noChangeArrowheads="1"/>
            </p:cNvPicPr>
            <p:nvPr/>
          </p:nvPicPr>
          <p:blipFill>
            <a:blip r:embed="rId27" cstate="print"/>
            <a:srcRect/>
            <a:stretch>
              <a:fillRect/>
            </a:stretch>
          </p:blipFill>
          <p:spPr bwMode="auto">
            <a:xfrm>
              <a:off x="1752600" y="5181600"/>
              <a:ext cx="1219200" cy="1143000"/>
            </a:xfrm>
            <a:prstGeom prst="rect">
              <a:avLst/>
            </a:prstGeom>
            <a:noFill/>
          </p:spPr>
        </p:pic>
        <p:pic>
          <p:nvPicPr>
            <p:cNvPr id="7198" name="Picture 30" descr="F:\chaithra education documents\IARI education\research work\PhD research photos\6869\6869\IMG_20201031_105855 final.jpg"/>
            <p:cNvPicPr>
              <a:picLocks noChangeAspect="1" noChangeArrowheads="1"/>
            </p:cNvPicPr>
            <p:nvPr/>
          </p:nvPicPr>
          <p:blipFill>
            <a:blip r:embed="rId28" cstate="print"/>
            <a:srcRect/>
            <a:stretch>
              <a:fillRect/>
            </a:stretch>
          </p:blipFill>
          <p:spPr bwMode="auto">
            <a:xfrm>
              <a:off x="2971800" y="5181599"/>
              <a:ext cx="1219200" cy="1143001"/>
            </a:xfrm>
            <a:prstGeom prst="rect">
              <a:avLst/>
            </a:prstGeom>
            <a:noFill/>
          </p:spPr>
        </p:pic>
        <p:pic>
          <p:nvPicPr>
            <p:cNvPr id="7199" name="Picture 31" descr="F:\chaithra education documents\IARI education\research work\PhD research photos\7173\7173\IMG_20201026_122332 final (1).jpg"/>
            <p:cNvPicPr>
              <a:picLocks noChangeAspect="1" noChangeArrowheads="1"/>
            </p:cNvPicPr>
            <p:nvPr/>
          </p:nvPicPr>
          <p:blipFill>
            <a:blip r:embed="rId29" cstate="print"/>
            <a:srcRect/>
            <a:stretch>
              <a:fillRect/>
            </a:stretch>
          </p:blipFill>
          <p:spPr bwMode="auto">
            <a:xfrm>
              <a:off x="4191000" y="5181600"/>
              <a:ext cx="1219200" cy="1143000"/>
            </a:xfrm>
            <a:prstGeom prst="rect">
              <a:avLst/>
            </a:prstGeom>
            <a:noFill/>
          </p:spPr>
        </p:pic>
        <p:pic>
          <p:nvPicPr>
            <p:cNvPr id="7200" name="Picture 32" descr="F:\chaithra education documents\IARI education\research work\PhD research photos\7438\7438\IMG_20201026_121925.jpg"/>
            <p:cNvPicPr>
              <a:picLocks noChangeAspect="1" noChangeArrowheads="1"/>
            </p:cNvPicPr>
            <p:nvPr/>
          </p:nvPicPr>
          <p:blipFill>
            <a:blip r:embed="rId30" cstate="print"/>
            <a:srcRect/>
            <a:stretch>
              <a:fillRect/>
            </a:stretch>
          </p:blipFill>
          <p:spPr bwMode="auto">
            <a:xfrm>
              <a:off x="6553201" y="5181600"/>
              <a:ext cx="1143000" cy="1143000"/>
            </a:xfrm>
            <a:prstGeom prst="rect">
              <a:avLst/>
            </a:prstGeom>
            <a:noFill/>
          </p:spPr>
        </p:pic>
        <p:pic>
          <p:nvPicPr>
            <p:cNvPr id="7201" name="Picture 33" descr="F:\chaithra education documents\IARI education\research work\PhD research photos\7414\7414\IMG_20201014_113446 final (1).jpg"/>
            <p:cNvPicPr>
              <a:picLocks noChangeAspect="1" noChangeArrowheads="1"/>
            </p:cNvPicPr>
            <p:nvPr/>
          </p:nvPicPr>
          <p:blipFill>
            <a:blip r:embed="rId31" cstate="print"/>
            <a:srcRect/>
            <a:stretch>
              <a:fillRect/>
            </a:stretch>
          </p:blipFill>
          <p:spPr bwMode="auto">
            <a:xfrm>
              <a:off x="5410200" y="5181600"/>
              <a:ext cx="1143000" cy="1143000"/>
            </a:xfrm>
            <a:prstGeom prst="rect">
              <a:avLst/>
            </a:prstGeom>
            <a:noFill/>
          </p:spPr>
        </p:pic>
        <p:sp>
          <p:nvSpPr>
            <p:cNvPr id="62" name="TextBox 61"/>
            <p:cNvSpPr txBox="1"/>
            <p:nvPr/>
          </p:nvSpPr>
          <p:spPr>
            <a:xfrm>
              <a:off x="1676400" y="6858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2895600" y="6858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3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114800" y="6858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4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5334000" y="6858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5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6477000" y="6858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6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533400" y="18288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7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1676400" y="18288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8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114800" y="18288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0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533400" y="2895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3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676400" y="2895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4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334000" y="18288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1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895600" y="18288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9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895600" y="2893368"/>
              <a:ext cx="5275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5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533400" y="41148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9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4114800" y="2895600"/>
              <a:ext cx="6200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6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5334000" y="2895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7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6477000" y="28933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8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6477000" y="18265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2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1676400" y="51793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6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6477000" y="403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4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5334000" y="403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3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4114800" y="403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2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2895600" y="403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1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1676400" y="4038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0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895600" y="51793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7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114800" y="51793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8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334000" y="5181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9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6480845" y="51793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30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533400" y="51793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5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00" name="Title 1"/>
          <p:cNvSpPr txBox="1">
            <a:spLocks/>
          </p:cNvSpPr>
          <p:nvPr/>
        </p:nvSpPr>
        <p:spPr>
          <a:xfrm>
            <a:off x="533400" y="5943600"/>
            <a:ext cx="8229600" cy="41116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Supplementary</a:t>
            </a:r>
            <a:r>
              <a:rPr kumimoji="0" lang="en-US" sz="1400" b="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 Figure 1a</a:t>
            </a: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: </a:t>
            </a:r>
            <a:r>
              <a:rPr lang="en-US" sz="1400" dirty="0" smtClean="0">
                <a:latin typeface="Times New Roman" pitchFamily="18" charset="0"/>
                <a:ea typeface="+mj-ea"/>
                <a:cs typeface="Times New Roman" pitchFamily="18" charset="0"/>
              </a:rPr>
              <a:t>Cultural </a:t>
            </a: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 characters of  Thirty  </a:t>
            </a:r>
            <a:r>
              <a:rPr kumimoji="0" lang="en-US" sz="1400" b="0" i="1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B. </a:t>
            </a:r>
            <a:r>
              <a:rPr kumimoji="0" lang="en-US" sz="1400" b="0" i="1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bassiana</a:t>
            </a:r>
            <a:r>
              <a:rPr kumimoji="0" lang="en-US" sz="1400" b="0" i="1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 </a:t>
            </a:r>
            <a:r>
              <a:rPr kumimoji="0" lang="en-US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isolates on PDA  medium after 16  DAI.</a:t>
            </a:r>
            <a:r>
              <a:rPr kumimoji="0" lang="en-US" sz="1400" b="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Times New Roman" pitchFamily="18" charset="0"/>
                <a:ea typeface="+mj-ea"/>
                <a:cs typeface="Times New Roman" pitchFamily="18" charset="0"/>
              </a:rPr>
              <a:t> (A) forward view</a:t>
            </a:r>
            <a:endParaRPr kumimoji="0" lang="en-US" sz="1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BBBDC9BF-F256-4914-A2F9-4FA6508F0F71}"/>
              </a:ext>
            </a:extLst>
          </p:cNvPr>
          <p:cNvGraphicFramePr/>
          <p:nvPr/>
        </p:nvGraphicFramePr>
        <p:xfrm>
          <a:off x="838201" y="838200"/>
          <a:ext cx="7315200" cy="3657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/>
          <p:cNvSpPr/>
          <p:nvPr/>
        </p:nvSpPr>
        <p:spPr>
          <a:xfrm>
            <a:off x="762000" y="4724400"/>
            <a:ext cx="73152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9: Mycosis (%)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T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truncatus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by different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bassiana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isolates after different intervals post infection. (A) 5DAI, (B) 8 DAI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62"/>
          <p:cNvGrpSpPr/>
          <p:nvPr/>
        </p:nvGrpSpPr>
        <p:grpSpPr>
          <a:xfrm>
            <a:off x="990600" y="304800"/>
            <a:ext cx="7315200" cy="5715000"/>
            <a:chOff x="0" y="228600"/>
            <a:chExt cx="6934201" cy="5413397"/>
          </a:xfrm>
        </p:grpSpPr>
        <p:pic>
          <p:nvPicPr>
            <p:cNvPr id="35842" name="Picture 2" descr="F:\chaithra education documents\IARI education\research work\PhD research photos\4513\4513\IMG_20201009_111428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71882" y="228600"/>
              <a:ext cx="1078223" cy="1143000"/>
            </a:xfrm>
            <a:prstGeom prst="rect">
              <a:avLst/>
            </a:prstGeom>
            <a:noFill/>
          </p:spPr>
        </p:pic>
        <p:pic>
          <p:nvPicPr>
            <p:cNvPr id="35843" name="Picture 3" descr="F:\chaithra education documents\IARI education\research work\PhD research photos\4563\4563\IMG_20201031_110055 final (r)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143000" y="228600"/>
              <a:ext cx="1084651" cy="1147409"/>
            </a:xfrm>
            <a:prstGeom prst="rect">
              <a:avLst/>
            </a:prstGeom>
            <a:noFill/>
          </p:spPr>
        </p:pic>
        <p:pic>
          <p:nvPicPr>
            <p:cNvPr id="35844" name="Picture 4" descr="F:\chaithra education documents\IARI education\research work\PhD research photos\6527\6527\IMG_20201026_121904 final (2)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2209800" y="228600"/>
              <a:ext cx="1143000" cy="1143000"/>
            </a:xfrm>
            <a:prstGeom prst="rect">
              <a:avLst/>
            </a:prstGeom>
            <a:noFill/>
          </p:spPr>
        </p:pic>
        <p:pic>
          <p:nvPicPr>
            <p:cNvPr id="35845" name="Picture 5" descr="F:\chaithra education documents\IARI education\research work\PhD research photos\7130\7130\P1019482 final (1).JP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3352800" y="228600"/>
              <a:ext cx="1233953" cy="1143000"/>
            </a:xfrm>
            <a:prstGeom prst="rect">
              <a:avLst/>
            </a:prstGeom>
            <a:noFill/>
          </p:spPr>
        </p:pic>
        <p:pic>
          <p:nvPicPr>
            <p:cNvPr id="35846" name="Picture 6" descr="F:\chaithra education documents\IARI education\research work\PhD research photos\4668\4668\IMG_20201031_110012 final (r).jp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4572000" y="228600"/>
              <a:ext cx="1222488" cy="1143000"/>
            </a:xfrm>
            <a:prstGeom prst="rect">
              <a:avLst/>
            </a:prstGeom>
            <a:noFill/>
          </p:spPr>
        </p:pic>
        <p:pic>
          <p:nvPicPr>
            <p:cNvPr id="35847" name="Picture 7" descr="F:\chaithra education documents\IARI education\research work\PhD research photos\5408\5408\IMG_20201031_110037 final (R).jp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5791200" y="228600"/>
              <a:ext cx="1143000" cy="1143000"/>
            </a:xfrm>
            <a:prstGeom prst="rect">
              <a:avLst/>
            </a:prstGeom>
            <a:noFill/>
          </p:spPr>
        </p:pic>
        <p:pic>
          <p:nvPicPr>
            <p:cNvPr id="35848" name="Picture 8" descr="F:\chaithra education documents\IARI education\research work\PhD research photos\5409\5409\IMG_20201014_113327 final (r).jp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76201" y="1371600"/>
              <a:ext cx="1066800" cy="1066800"/>
            </a:xfrm>
            <a:prstGeom prst="rect">
              <a:avLst/>
            </a:prstGeom>
            <a:noFill/>
          </p:spPr>
        </p:pic>
        <p:pic>
          <p:nvPicPr>
            <p:cNvPr id="35849" name="Picture 9" descr="F:\chaithra education documents\IARI education\research work\PhD research photos\7127\7127\IMG_20201009_110710.jp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1143000" y="1371600"/>
              <a:ext cx="1123250" cy="1066800"/>
            </a:xfrm>
            <a:prstGeom prst="rect">
              <a:avLst/>
            </a:prstGeom>
            <a:noFill/>
          </p:spPr>
        </p:pic>
        <p:pic>
          <p:nvPicPr>
            <p:cNvPr id="35850" name="Picture 10" descr="F:\chaithra education documents\IARI education\research work\PhD research photos\7128\7128\IMG_20201031_105836 final (2).jpg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2209800" y="1371600"/>
              <a:ext cx="1143000" cy="1067180"/>
            </a:xfrm>
            <a:prstGeom prst="rect">
              <a:avLst/>
            </a:prstGeom>
            <a:noFill/>
          </p:spPr>
        </p:pic>
        <p:pic>
          <p:nvPicPr>
            <p:cNvPr id="35851" name="Picture 11" descr="F:\chaithra education documents\IARI education\research work\PhD research photos\4703\4703\IMG_20201014_114008 final.jpg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 flipH="1">
              <a:off x="3352800" y="1371600"/>
              <a:ext cx="1219200" cy="1066800"/>
            </a:xfrm>
            <a:prstGeom prst="rect">
              <a:avLst/>
            </a:prstGeom>
            <a:noFill/>
          </p:spPr>
        </p:pic>
        <p:pic>
          <p:nvPicPr>
            <p:cNvPr id="35852" name="Picture 12" descr="F:\chaithra education documents\IARI education\research work\PhD research photos\6645\6645\IMG_20201026_122304 final (2).jpg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4572000" y="1371600"/>
              <a:ext cx="1219200" cy="1066800"/>
            </a:xfrm>
            <a:prstGeom prst="rect">
              <a:avLst/>
            </a:prstGeom>
            <a:noFill/>
          </p:spPr>
        </p:pic>
        <p:pic>
          <p:nvPicPr>
            <p:cNvPr id="35853" name="Picture 13" descr="F:\chaithra education documents\IARI education\research work\PhD research photos\7042\7042\IMG_20201014_113521.jpg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5791200" y="1371600"/>
              <a:ext cx="1143000" cy="1066325"/>
            </a:xfrm>
            <a:prstGeom prst="rect">
              <a:avLst/>
            </a:prstGeom>
            <a:noFill/>
          </p:spPr>
        </p:pic>
        <p:pic>
          <p:nvPicPr>
            <p:cNvPr id="35854" name="Picture 14" descr="F:\chaithra education documents\IARI education\research work\PhD research photos\5549\5549\IMG_20201014_113936 final (2).jpg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76200" y="2438400"/>
              <a:ext cx="1066800" cy="1066800"/>
            </a:xfrm>
            <a:prstGeom prst="rect">
              <a:avLst/>
            </a:prstGeom>
            <a:noFill/>
          </p:spPr>
        </p:pic>
        <p:pic>
          <p:nvPicPr>
            <p:cNvPr id="35855" name="Picture 15" descr="F:\chaithra education documents\IARI education\research work\PhD research photos\6628\6628\IMG_20201014_113541 final (2).jpg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1143000" y="2438400"/>
              <a:ext cx="1066800" cy="1066800"/>
            </a:xfrm>
            <a:prstGeom prst="rect">
              <a:avLst/>
            </a:prstGeom>
            <a:noFill/>
          </p:spPr>
        </p:pic>
        <p:pic>
          <p:nvPicPr>
            <p:cNvPr id="35856" name="Picture 16" descr="F:\chaithra education documents\IARI education\research work\PhD research photos\7035\7035\IMG_20201014_113619 final.jpg"/>
            <p:cNvPicPr>
              <a:picLocks noChangeAspect="1"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2209801" y="2438400"/>
              <a:ext cx="1142999" cy="1066800"/>
            </a:xfrm>
            <a:prstGeom prst="rect">
              <a:avLst/>
            </a:prstGeom>
            <a:noFill/>
          </p:spPr>
        </p:pic>
        <p:pic>
          <p:nvPicPr>
            <p:cNvPr id="35857" name="Picture 17" descr="F:\chaithra education documents\IARI education\research work\PhD research photos\490\490\IMG_20201014_113721 final (R).jpg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3352800" y="2438400"/>
              <a:ext cx="1219200" cy="1066800"/>
            </a:xfrm>
            <a:prstGeom prst="rect">
              <a:avLst/>
            </a:prstGeom>
            <a:noFill/>
          </p:spPr>
        </p:pic>
        <p:pic>
          <p:nvPicPr>
            <p:cNvPr id="35858" name="Picture 18" descr="F:\chaithra education documents\IARI education\research work\PhD research photos\913\913\IMG_20201014_113812 final (r).jpg"/>
            <p:cNvPicPr>
              <a:picLocks noChangeAspect="1" noChangeArrowheads="1"/>
            </p:cNvPicPr>
            <p:nvPr/>
          </p:nvPicPr>
          <p:blipFill>
            <a:blip r:embed="rId18" cstate="print"/>
            <a:srcRect/>
            <a:stretch>
              <a:fillRect/>
            </a:stretch>
          </p:blipFill>
          <p:spPr bwMode="auto">
            <a:xfrm>
              <a:off x="4572000" y="2438401"/>
              <a:ext cx="1219200" cy="1066800"/>
            </a:xfrm>
            <a:prstGeom prst="rect">
              <a:avLst/>
            </a:prstGeom>
            <a:noFill/>
          </p:spPr>
        </p:pic>
        <p:pic>
          <p:nvPicPr>
            <p:cNvPr id="35859" name="Picture 19" descr="F:\chaithra education documents\IARI education\research work\PhD research photos\4925\4925\P1019215.JPG"/>
            <p:cNvPicPr>
              <a:picLocks noChangeAspect="1" noChangeArrowheads="1"/>
            </p:cNvPicPr>
            <p:nvPr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5791201" y="2438400"/>
              <a:ext cx="1143000" cy="1066800"/>
            </a:xfrm>
            <a:prstGeom prst="rect">
              <a:avLst/>
            </a:prstGeom>
            <a:noFill/>
          </p:spPr>
        </p:pic>
        <p:pic>
          <p:nvPicPr>
            <p:cNvPr id="35860" name="Picture 20" descr="F:\chaithra education documents\IARI education\research work\PhD research photos\5411\5411\IMG_20201014_113639 final.jpg"/>
            <p:cNvPicPr>
              <a:picLocks noChangeAspect="1" noChangeArrowheads="1"/>
            </p:cNvPicPr>
            <p:nvPr/>
          </p:nvPicPr>
          <p:blipFill>
            <a:blip r:embed="rId20" cstate="print"/>
            <a:srcRect/>
            <a:stretch>
              <a:fillRect/>
            </a:stretch>
          </p:blipFill>
          <p:spPr bwMode="auto">
            <a:xfrm>
              <a:off x="76201" y="3505200"/>
              <a:ext cx="1066800" cy="1066800"/>
            </a:xfrm>
            <a:prstGeom prst="rect">
              <a:avLst/>
            </a:prstGeom>
            <a:noFill/>
          </p:spPr>
        </p:pic>
        <p:pic>
          <p:nvPicPr>
            <p:cNvPr id="35861" name="Picture 21" descr="F:\chaithra education documents\IARI education\research work\PhD research photos\5412\5412\IMG_20201009_111203.jpg"/>
            <p:cNvPicPr>
              <a:picLocks noChangeAspect="1" noChangeArrowheads="1"/>
            </p:cNvPicPr>
            <p:nvPr/>
          </p:nvPicPr>
          <p:blipFill>
            <a:blip r:embed="rId21" cstate="print"/>
            <a:srcRect/>
            <a:stretch>
              <a:fillRect/>
            </a:stretch>
          </p:blipFill>
          <p:spPr bwMode="auto">
            <a:xfrm>
              <a:off x="1143000" y="3505200"/>
              <a:ext cx="1066800" cy="1066800"/>
            </a:xfrm>
            <a:prstGeom prst="rect">
              <a:avLst/>
            </a:prstGeom>
            <a:noFill/>
          </p:spPr>
        </p:pic>
        <p:pic>
          <p:nvPicPr>
            <p:cNvPr id="35862" name="Picture 22" descr="F:\chaithra education documents\IARI education\research work\PhD research photos\6897\6897\IMG_20201031_105809 final (2).jpg"/>
            <p:cNvPicPr>
              <a:picLocks noChangeAspect="1" noChangeArrowheads="1"/>
            </p:cNvPicPr>
            <p:nvPr/>
          </p:nvPicPr>
          <p:blipFill>
            <a:blip r:embed="rId22" cstate="print"/>
            <a:srcRect/>
            <a:stretch>
              <a:fillRect/>
            </a:stretch>
          </p:blipFill>
          <p:spPr bwMode="auto">
            <a:xfrm>
              <a:off x="2209800" y="3505200"/>
              <a:ext cx="1143000" cy="1066800"/>
            </a:xfrm>
            <a:prstGeom prst="rect">
              <a:avLst/>
            </a:prstGeom>
            <a:noFill/>
          </p:spPr>
        </p:pic>
        <p:pic>
          <p:nvPicPr>
            <p:cNvPr id="35863" name="Picture 23" descr="F:\chaithra education documents\IARI education\research work\PhD research photos\6063\6063\IMG_20201026_122157 final (2).jpg"/>
            <p:cNvPicPr>
              <a:picLocks noChangeAspect="1" noChangeArrowheads="1"/>
            </p:cNvPicPr>
            <p:nvPr/>
          </p:nvPicPr>
          <p:blipFill>
            <a:blip r:embed="rId23" cstate="print"/>
            <a:srcRect/>
            <a:stretch>
              <a:fillRect/>
            </a:stretch>
          </p:blipFill>
          <p:spPr bwMode="auto">
            <a:xfrm>
              <a:off x="3352800" y="3505200"/>
              <a:ext cx="1219200" cy="1069434"/>
            </a:xfrm>
            <a:prstGeom prst="rect">
              <a:avLst/>
            </a:prstGeom>
            <a:noFill/>
          </p:spPr>
        </p:pic>
        <p:pic>
          <p:nvPicPr>
            <p:cNvPr id="35864" name="Picture 24" descr="F:\chaithra education documents\IARI education\research work\PhD research photos\6106\6106\IMG_20201014_113741 final (1).jpg"/>
            <p:cNvPicPr>
              <a:picLocks noChangeAspect="1" noChangeArrowheads="1"/>
            </p:cNvPicPr>
            <p:nvPr/>
          </p:nvPicPr>
          <p:blipFill>
            <a:blip r:embed="rId24" cstate="print"/>
            <a:srcRect/>
            <a:stretch>
              <a:fillRect/>
            </a:stretch>
          </p:blipFill>
          <p:spPr bwMode="auto">
            <a:xfrm>
              <a:off x="4572000" y="3505200"/>
              <a:ext cx="1219200" cy="1066800"/>
            </a:xfrm>
            <a:prstGeom prst="rect">
              <a:avLst/>
            </a:prstGeom>
            <a:noFill/>
          </p:spPr>
        </p:pic>
        <p:pic>
          <p:nvPicPr>
            <p:cNvPr id="35865" name="Picture 25" descr="F:\chaithra education documents\IARI education\research work\PhD research photos\5328\5328\IMG_20201014_113829 final (r) (1).jpg"/>
            <p:cNvPicPr>
              <a:picLocks noChangeAspect="1" noChangeArrowheads="1"/>
            </p:cNvPicPr>
            <p:nvPr/>
          </p:nvPicPr>
          <p:blipFill>
            <a:blip r:embed="rId25" cstate="print"/>
            <a:srcRect/>
            <a:stretch>
              <a:fillRect/>
            </a:stretch>
          </p:blipFill>
          <p:spPr bwMode="auto">
            <a:xfrm>
              <a:off x="5791200" y="3505200"/>
              <a:ext cx="1143000" cy="1066800"/>
            </a:xfrm>
            <a:prstGeom prst="rect">
              <a:avLst/>
            </a:prstGeom>
            <a:noFill/>
          </p:spPr>
        </p:pic>
        <p:pic>
          <p:nvPicPr>
            <p:cNvPr id="35866" name="Picture 26" descr="F:\chaithra education documents\IARI education\research work\PhD research photos\7126\7126\IMG_20201014_113135 final (2).jpg"/>
            <p:cNvPicPr>
              <a:picLocks noChangeAspect="1" noChangeArrowheads="1"/>
            </p:cNvPicPr>
            <p:nvPr/>
          </p:nvPicPr>
          <p:blipFill>
            <a:blip r:embed="rId26" cstate="print"/>
            <a:srcRect/>
            <a:stretch>
              <a:fillRect/>
            </a:stretch>
          </p:blipFill>
          <p:spPr bwMode="auto">
            <a:xfrm>
              <a:off x="68110" y="4572000"/>
              <a:ext cx="1074890" cy="1066800"/>
            </a:xfrm>
            <a:prstGeom prst="rect">
              <a:avLst/>
            </a:prstGeom>
            <a:noFill/>
          </p:spPr>
        </p:pic>
        <p:pic>
          <p:nvPicPr>
            <p:cNvPr id="35869" name="Picture 29" descr="F:\chaithra education documents\IARI education\research work\PhD research photos\7102\7102\IMG_20201009_111238.jpg"/>
            <p:cNvPicPr>
              <a:picLocks noChangeAspect="1" noChangeArrowheads="1"/>
            </p:cNvPicPr>
            <p:nvPr/>
          </p:nvPicPr>
          <p:blipFill>
            <a:blip r:embed="rId27" cstate="print"/>
            <a:srcRect/>
            <a:stretch>
              <a:fillRect/>
            </a:stretch>
          </p:blipFill>
          <p:spPr bwMode="auto">
            <a:xfrm>
              <a:off x="1143000" y="4572000"/>
              <a:ext cx="1066800" cy="1066800"/>
            </a:xfrm>
            <a:prstGeom prst="rect">
              <a:avLst/>
            </a:prstGeom>
            <a:noFill/>
          </p:spPr>
        </p:pic>
        <p:pic>
          <p:nvPicPr>
            <p:cNvPr id="35870" name="Picture 30" descr="F:\chaithra education documents\IARI education\research work\PhD research photos\6869\6869\IMG_20201031_105928 final.jpg"/>
            <p:cNvPicPr>
              <a:picLocks noChangeAspect="1" noChangeArrowheads="1"/>
            </p:cNvPicPr>
            <p:nvPr/>
          </p:nvPicPr>
          <p:blipFill>
            <a:blip r:embed="rId28" cstate="print"/>
            <a:srcRect/>
            <a:stretch>
              <a:fillRect/>
            </a:stretch>
          </p:blipFill>
          <p:spPr bwMode="auto">
            <a:xfrm>
              <a:off x="2209800" y="4572000"/>
              <a:ext cx="1143000" cy="1066800"/>
            </a:xfrm>
            <a:prstGeom prst="rect">
              <a:avLst/>
            </a:prstGeom>
            <a:noFill/>
          </p:spPr>
        </p:pic>
        <p:pic>
          <p:nvPicPr>
            <p:cNvPr id="35871" name="Picture 31" descr="F:\chaithra education documents\IARI education\research work\PhD research photos\7173\7173\IMG_20201026_122332 final (2).jpg"/>
            <p:cNvPicPr>
              <a:picLocks noChangeAspect="1" noChangeArrowheads="1"/>
            </p:cNvPicPr>
            <p:nvPr/>
          </p:nvPicPr>
          <p:blipFill>
            <a:blip r:embed="rId29" cstate="print"/>
            <a:srcRect/>
            <a:stretch>
              <a:fillRect/>
            </a:stretch>
          </p:blipFill>
          <p:spPr bwMode="auto">
            <a:xfrm>
              <a:off x="3352800" y="4572000"/>
              <a:ext cx="1219199" cy="1069997"/>
            </a:xfrm>
            <a:prstGeom prst="rect">
              <a:avLst/>
            </a:prstGeom>
            <a:noFill/>
          </p:spPr>
        </p:pic>
        <p:pic>
          <p:nvPicPr>
            <p:cNvPr id="35872" name="Picture 32" descr="F:\chaithra education documents\IARI education\research work\PhD research photos\7414\7414\IMG_20201014_113446 final (2).jpg"/>
            <p:cNvPicPr>
              <a:picLocks noChangeAspect="1" noChangeArrowheads="1"/>
            </p:cNvPicPr>
            <p:nvPr/>
          </p:nvPicPr>
          <p:blipFill>
            <a:blip r:embed="rId30" cstate="print"/>
            <a:srcRect/>
            <a:stretch>
              <a:fillRect/>
            </a:stretch>
          </p:blipFill>
          <p:spPr bwMode="auto">
            <a:xfrm>
              <a:off x="4572000" y="4572001"/>
              <a:ext cx="1219200" cy="1066800"/>
            </a:xfrm>
            <a:prstGeom prst="rect">
              <a:avLst/>
            </a:prstGeom>
            <a:noFill/>
          </p:spPr>
        </p:pic>
        <p:pic>
          <p:nvPicPr>
            <p:cNvPr id="35873" name="Picture 33" descr="F:\chaithra education documents\IARI education\research work\PhD research photos\7438\7438\IMG_20201026_121932.jpg"/>
            <p:cNvPicPr>
              <a:picLocks noChangeAspect="1" noChangeArrowheads="1"/>
            </p:cNvPicPr>
            <p:nvPr/>
          </p:nvPicPr>
          <p:blipFill>
            <a:blip r:embed="rId31" cstate="print"/>
            <a:srcRect/>
            <a:stretch>
              <a:fillRect/>
            </a:stretch>
          </p:blipFill>
          <p:spPr bwMode="auto">
            <a:xfrm>
              <a:off x="5791200" y="4572000"/>
              <a:ext cx="1143000" cy="1066800"/>
            </a:xfrm>
            <a:prstGeom prst="rect">
              <a:avLst/>
            </a:prstGeom>
            <a:noFill/>
          </p:spPr>
        </p:pic>
        <p:sp>
          <p:nvSpPr>
            <p:cNvPr id="32" name="TextBox 31"/>
            <p:cNvSpPr txBox="1"/>
            <p:nvPr/>
          </p:nvSpPr>
          <p:spPr>
            <a:xfrm>
              <a:off x="0" y="228601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066800" y="2286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133600" y="2286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3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276600" y="2286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4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495800" y="2286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5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715000" y="2286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6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0" y="13716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7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066800" y="13716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8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276600" y="1371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0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0" y="24384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3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066800" y="24384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4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4495800" y="13716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1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133600" y="1371600"/>
              <a:ext cx="3810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9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133600" y="2436168"/>
              <a:ext cx="52753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5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0" y="3505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9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3276600" y="2438400"/>
              <a:ext cx="6200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6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495800" y="24384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7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715000" y="24361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8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715000" y="13693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12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066800" y="45697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6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5715000" y="3505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4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495800" y="3505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3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3276600" y="3505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2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133600" y="35029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1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066800" y="35052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0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133600" y="45697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7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276600" y="45720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8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495800" y="45720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9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5715000" y="4569768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30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0" y="4572000"/>
              <a:ext cx="4572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smtClean="0">
                  <a:solidFill>
                    <a:srgbClr val="FFFF00"/>
                  </a:solidFill>
                  <a:latin typeface="Times New Roman" pitchFamily="18" charset="0"/>
                  <a:cs typeface="Times New Roman" pitchFamily="18" charset="0"/>
                </a:rPr>
                <a:t>Bb25</a:t>
              </a:r>
              <a:endParaRPr lang="en-US" sz="900" b="1" dirty="0">
                <a:solidFill>
                  <a:srgbClr val="FFFF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64" name="Rectangle 63"/>
          <p:cNvSpPr/>
          <p:nvPr/>
        </p:nvSpPr>
        <p:spPr>
          <a:xfrm>
            <a:off x="609600" y="6211669"/>
            <a:ext cx="82296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ctr">
              <a:spcBef>
                <a:spcPct val="0"/>
              </a:spcBef>
              <a:defRPr/>
            </a:pP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1b : Cultural  characters of  Thirty 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bassiana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isolates on PDA  medium after 16  DAI. (B)  reverse view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84"/>
          <p:cNvGrpSpPr/>
          <p:nvPr/>
        </p:nvGrpSpPr>
        <p:grpSpPr>
          <a:xfrm>
            <a:off x="609600" y="228600"/>
            <a:ext cx="8229600" cy="6019800"/>
            <a:chOff x="381000" y="134779"/>
            <a:chExt cx="8229600" cy="6266022"/>
          </a:xfrm>
        </p:grpSpPr>
        <p:pic>
          <p:nvPicPr>
            <p:cNvPr id="34818" name="Picture 2" descr="F:\chaithra education documents\IARI education\research work\PhD research photos\4513\4513\Chaetomium_011231_010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81001" y="152401"/>
              <a:ext cx="1306052" cy="1371600"/>
            </a:xfrm>
            <a:prstGeom prst="rect">
              <a:avLst/>
            </a:prstGeom>
            <a:noFill/>
          </p:spPr>
        </p:pic>
        <p:pic>
          <p:nvPicPr>
            <p:cNvPr id="34819" name="Picture 3" descr="F:\chaithra education documents\IARI education\research work\PhD research photos\4563\beauveria011231_010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676400" y="152400"/>
              <a:ext cx="1371600" cy="1371600"/>
            </a:xfrm>
            <a:prstGeom prst="rect">
              <a:avLst/>
            </a:prstGeom>
            <a:noFill/>
          </p:spPr>
        </p:pic>
        <p:pic>
          <p:nvPicPr>
            <p:cNvPr id="34820" name="Picture 4" descr="F:\chaithra education documents\IARI education\research work\PhD research photos\6527\6527\beauveria011231_013.JPG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048000" y="152400"/>
              <a:ext cx="1447800" cy="1371600"/>
            </a:xfrm>
            <a:prstGeom prst="rect">
              <a:avLst/>
            </a:prstGeom>
            <a:noFill/>
          </p:spPr>
        </p:pic>
        <p:pic>
          <p:nvPicPr>
            <p:cNvPr id="34821" name="Picture 5" descr="F:\chaithra education documents\IARI education\research work\PhD research photos\7130\7130\beauveria001102_011.JPG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495800" y="152400"/>
              <a:ext cx="1371600" cy="1371600"/>
            </a:xfrm>
            <a:prstGeom prst="rect">
              <a:avLst/>
            </a:prstGeom>
            <a:noFill/>
          </p:spPr>
        </p:pic>
        <p:pic>
          <p:nvPicPr>
            <p:cNvPr id="34822" name="Picture 6" descr="F:\chaithra education documents\IARI education\research work\PhD research photos\4668\4668\beauveria011231_019.JPG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5867400" y="152400"/>
              <a:ext cx="1371600" cy="1371600"/>
            </a:xfrm>
            <a:prstGeom prst="rect">
              <a:avLst/>
            </a:prstGeom>
            <a:noFill/>
          </p:spPr>
        </p:pic>
        <p:pic>
          <p:nvPicPr>
            <p:cNvPr id="34823" name="Picture 7" descr="F:\chaithra education documents\IARI education\research work\PhD research photos\5408\5408\beauveria011231_003.JPG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7239000" y="152400"/>
              <a:ext cx="1295400" cy="1371600"/>
            </a:xfrm>
            <a:prstGeom prst="rect">
              <a:avLst/>
            </a:prstGeom>
            <a:noFill/>
          </p:spPr>
        </p:pic>
        <p:pic>
          <p:nvPicPr>
            <p:cNvPr id="34824" name="Picture 8" descr="F:\chaithra education documents\IARI education\research work\PhD research photos\5409\5409\beauveria011231_014.JPG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381000" y="1524000"/>
              <a:ext cx="1295400" cy="1219200"/>
            </a:xfrm>
            <a:prstGeom prst="rect">
              <a:avLst/>
            </a:prstGeom>
            <a:noFill/>
          </p:spPr>
        </p:pic>
        <p:pic>
          <p:nvPicPr>
            <p:cNvPr id="34825" name="Picture 9" descr="F:\chaithra education documents\IARI education\research work\PhD research photos\7127\7127\beauveria011231_010.JPG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1676400" y="1524000"/>
              <a:ext cx="1371600" cy="1219200"/>
            </a:xfrm>
            <a:prstGeom prst="rect">
              <a:avLst/>
            </a:prstGeom>
            <a:noFill/>
          </p:spPr>
        </p:pic>
        <p:pic>
          <p:nvPicPr>
            <p:cNvPr id="34826" name="Picture 10" descr="F:\chaithra education documents\IARI education\research work\PhD research photos\7128\7128\beauveria011231_012.JPG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3048000" y="1524000"/>
              <a:ext cx="1447800" cy="1219200"/>
            </a:xfrm>
            <a:prstGeom prst="rect">
              <a:avLst/>
            </a:prstGeom>
            <a:noFill/>
          </p:spPr>
        </p:pic>
        <p:pic>
          <p:nvPicPr>
            <p:cNvPr id="34827" name="Picture 11" descr="F:\chaithra education documents\IARI education\research work\PhD research photos\4703\4703\beauveria011231_012.JPG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4488027" y="1524000"/>
              <a:ext cx="1379373" cy="1219200"/>
            </a:xfrm>
            <a:prstGeom prst="rect">
              <a:avLst/>
            </a:prstGeom>
            <a:noFill/>
          </p:spPr>
        </p:pic>
        <p:pic>
          <p:nvPicPr>
            <p:cNvPr id="34828" name="Picture 12" descr="F:\chaithra education documents\IARI education\research work\PhD research photos\6645\6645\Chaetomium_011231_011.JPG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5867400" y="1524000"/>
              <a:ext cx="1371600" cy="1219200"/>
            </a:xfrm>
            <a:prstGeom prst="rect">
              <a:avLst/>
            </a:prstGeom>
            <a:noFill/>
          </p:spPr>
        </p:pic>
        <p:pic>
          <p:nvPicPr>
            <p:cNvPr id="34829" name="Picture 13" descr="F:\chaithra education documents\IARI education\research work\PhD research photos\7042\7042\Chaetomium_011231_002.JPG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7239000" y="1524000"/>
              <a:ext cx="1295399" cy="1219200"/>
            </a:xfrm>
            <a:prstGeom prst="rect">
              <a:avLst/>
            </a:prstGeom>
            <a:noFill/>
          </p:spPr>
        </p:pic>
        <p:pic>
          <p:nvPicPr>
            <p:cNvPr id="34830" name="Picture 14" descr="F:\chaithra education documents\IARI education\research work\PhD research photos\5549\5549\beauveria011231_023.JPG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381000" y="2743200"/>
              <a:ext cx="1295400" cy="1219199"/>
            </a:xfrm>
            <a:prstGeom prst="rect">
              <a:avLst/>
            </a:prstGeom>
            <a:noFill/>
          </p:spPr>
        </p:pic>
        <p:pic>
          <p:nvPicPr>
            <p:cNvPr id="34831" name="Picture 15" descr="F:\chaithra education documents\IARI education\research work\PhD research photos\6628\6628\beauveria011231_009.JPG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1676400" y="2743200"/>
              <a:ext cx="1371600" cy="1219200"/>
            </a:xfrm>
            <a:prstGeom prst="rect">
              <a:avLst/>
            </a:prstGeom>
            <a:noFill/>
          </p:spPr>
        </p:pic>
        <p:pic>
          <p:nvPicPr>
            <p:cNvPr id="34832" name="Picture 16" descr="F:\chaithra education documents\IARI education\research work\PhD research photos\7035\7035\beauveria011231_010.JPG"/>
            <p:cNvPicPr>
              <a:picLocks noChangeAspect="1"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3048000" y="2743200"/>
              <a:ext cx="1447800" cy="1219200"/>
            </a:xfrm>
            <a:prstGeom prst="rect">
              <a:avLst/>
            </a:prstGeom>
            <a:noFill/>
          </p:spPr>
        </p:pic>
        <p:pic>
          <p:nvPicPr>
            <p:cNvPr id="34833" name="Picture 17" descr="F:\chaithra education documents\IARI education\research work\PhD research photos\490\490\beauveria011231_012.JPG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4495800" y="2743201"/>
              <a:ext cx="1371600" cy="1219200"/>
            </a:xfrm>
            <a:prstGeom prst="rect">
              <a:avLst/>
            </a:prstGeom>
            <a:noFill/>
          </p:spPr>
        </p:pic>
        <p:pic>
          <p:nvPicPr>
            <p:cNvPr id="34834" name="Picture 18" descr="F:\chaithra education documents\IARI education\research work\PhD research photos\4925\4925\Chaetomium_011231_015.JPG"/>
            <p:cNvPicPr>
              <a:picLocks noChangeAspect="1" noChangeArrowheads="1"/>
            </p:cNvPicPr>
            <p:nvPr/>
          </p:nvPicPr>
          <p:blipFill>
            <a:blip r:embed="rId18" cstate="print"/>
            <a:srcRect/>
            <a:stretch>
              <a:fillRect/>
            </a:stretch>
          </p:blipFill>
          <p:spPr bwMode="auto">
            <a:xfrm>
              <a:off x="7239000" y="2743200"/>
              <a:ext cx="1295400" cy="1219200"/>
            </a:xfrm>
            <a:prstGeom prst="rect">
              <a:avLst/>
            </a:prstGeom>
            <a:noFill/>
          </p:spPr>
        </p:pic>
        <p:pic>
          <p:nvPicPr>
            <p:cNvPr id="34835" name="Picture 19" descr="F:\chaithra education documents\IARI education\research work\PhD research photos\5411\5411\beauveria011231_008.JPG"/>
            <p:cNvPicPr>
              <a:picLocks noChangeAspect="1" noChangeArrowheads="1"/>
            </p:cNvPicPr>
            <p:nvPr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381000" y="3962400"/>
              <a:ext cx="1295400" cy="1219200"/>
            </a:xfrm>
            <a:prstGeom prst="rect">
              <a:avLst/>
            </a:prstGeom>
            <a:noFill/>
          </p:spPr>
        </p:pic>
        <p:pic>
          <p:nvPicPr>
            <p:cNvPr id="34836" name="Picture 20" descr="F:\chaithra education documents\IARI education\research work\PhD research photos\5412\5412\beauveria011231_020.JPG"/>
            <p:cNvPicPr>
              <a:picLocks noChangeAspect="1" noChangeArrowheads="1"/>
            </p:cNvPicPr>
            <p:nvPr/>
          </p:nvPicPr>
          <p:blipFill>
            <a:blip r:embed="rId20" cstate="print"/>
            <a:srcRect/>
            <a:stretch>
              <a:fillRect/>
            </a:stretch>
          </p:blipFill>
          <p:spPr bwMode="auto">
            <a:xfrm>
              <a:off x="1676400" y="3945986"/>
              <a:ext cx="1371600" cy="1235613"/>
            </a:xfrm>
            <a:prstGeom prst="rect">
              <a:avLst/>
            </a:prstGeom>
            <a:noFill/>
          </p:spPr>
        </p:pic>
        <p:pic>
          <p:nvPicPr>
            <p:cNvPr id="34837" name="Picture 21" descr="F:\chaithra education documents\IARI education\research work\PhD research photos\6897\6897\beauveria011231_011.JPG"/>
            <p:cNvPicPr>
              <a:picLocks noChangeAspect="1" noChangeArrowheads="1"/>
            </p:cNvPicPr>
            <p:nvPr/>
          </p:nvPicPr>
          <p:blipFill>
            <a:blip r:embed="rId21" cstate="print"/>
            <a:srcRect/>
            <a:stretch>
              <a:fillRect/>
            </a:stretch>
          </p:blipFill>
          <p:spPr bwMode="auto">
            <a:xfrm>
              <a:off x="3048000" y="3962400"/>
              <a:ext cx="1447800" cy="1219200"/>
            </a:xfrm>
            <a:prstGeom prst="rect">
              <a:avLst/>
            </a:prstGeom>
            <a:noFill/>
          </p:spPr>
        </p:pic>
        <p:pic>
          <p:nvPicPr>
            <p:cNvPr id="34838" name="Picture 22" descr="F:\chaithra education documents\IARI education\research work\PhD research photos\6063\6063\beauveria011231_010.JPG"/>
            <p:cNvPicPr>
              <a:picLocks noChangeAspect="1" noChangeArrowheads="1"/>
            </p:cNvPicPr>
            <p:nvPr/>
          </p:nvPicPr>
          <p:blipFill>
            <a:blip r:embed="rId22" cstate="print"/>
            <a:srcRect/>
            <a:stretch>
              <a:fillRect/>
            </a:stretch>
          </p:blipFill>
          <p:spPr bwMode="auto">
            <a:xfrm>
              <a:off x="4495800" y="3962400"/>
              <a:ext cx="1371600" cy="1219200"/>
            </a:xfrm>
            <a:prstGeom prst="rect">
              <a:avLst/>
            </a:prstGeom>
            <a:noFill/>
          </p:spPr>
        </p:pic>
        <p:pic>
          <p:nvPicPr>
            <p:cNvPr id="34839" name="Picture 23" descr="F:\chaithra education documents\IARI education\research work\PhD research photos\6106\6106\beauveria011231_017.JPG"/>
            <p:cNvPicPr>
              <a:picLocks noChangeAspect="1" noChangeArrowheads="1"/>
            </p:cNvPicPr>
            <p:nvPr/>
          </p:nvPicPr>
          <p:blipFill>
            <a:blip r:embed="rId23" cstate="print"/>
            <a:srcRect/>
            <a:stretch>
              <a:fillRect/>
            </a:stretch>
          </p:blipFill>
          <p:spPr bwMode="auto">
            <a:xfrm>
              <a:off x="5867400" y="3962400"/>
              <a:ext cx="1371600" cy="1219200"/>
            </a:xfrm>
            <a:prstGeom prst="rect">
              <a:avLst/>
            </a:prstGeom>
            <a:noFill/>
          </p:spPr>
        </p:pic>
        <p:pic>
          <p:nvPicPr>
            <p:cNvPr id="34840" name="Picture 24" descr="F:\chaithra education documents\IARI education\research work\PhD research photos\5328\5328\beauveria011231_012.JPG"/>
            <p:cNvPicPr>
              <a:picLocks noChangeAspect="1" noChangeArrowheads="1"/>
            </p:cNvPicPr>
            <p:nvPr/>
          </p:nvPicPr>
          <p:blipFill>
            <a:blip r:embed="rId24" cstate="print"/>
            <a:srcRect/>
            <a:stretch>
              <a:fillRect/>
            </a:stretch>
          </p:blipFill>
          <p:spPr bwMode="auto">
            <a:xfrm>
              <a:off x="7239000" y="3962400"/>
              <a:ext cx="1295400" cy="1219200"/>
            </a:xfrm>
            <a:prstGeom prst="rect">
              <a:avLst/>
            </a:prstGeom>
            <a:noFill/>
          </p:spPr>
        </p:pic>
        <p:pic>
          <p:nvPicPr>
            <p:cNvPr id="34841" name="Picture 25" descr="F:\chaithra education documents\IARI education\research work\PhD research photos\7126\7126\beauveria011231_015.JPG"/>
            <p:cNvPicPr>
              <a:picLocks noChangeAspect="1" noChangeArrowheads="1"/>
            </p:cNvPicPr>
            <p:nvPr/>
          </p:nvPicPr>
          <p:blipFill>
            <a:blip r:embed="rId25" cstate="print"/>
            <a:srcRect/>
            <a:stretch>
              <a:fillRect/>
            </a:stretch>
          </p:blipFill>
          <p:spPr bwMode="auto">
            <a:xfrm>
              <a:off x="381000" y="5181600"/>
              <a:ext cx="1295400" cy="1219201"/>
            </a:xfrm>
            <a:prstGeom prst="rect">
              <a:avLst/>
            </a:prstGeom>
            <a:noFill/>
          </p:spPr>
        </p:pic>
        <p:pic>
          <p:nvPicPr>
            <p:cNvPr id="34842" name="Picture 26" descr="F:\chaithra education documents\IARI education\research work\PhD research photos\7102\7102\beauveria011231_008.JPG"/>
            <p:cNvPicPr>
              <a:picLocks noChangeAspect="1" noChangeArrowheads="1"/>
            </p:cNvPicPr>
            <p:nvPr/>
          </p:nvPicPr>
          <p:blipFill>
            <a:blip r:embed="rId26" cstate="print"/>
            <a:srcRect/>
            <a:stretch>
              <a:fillRect/>
            </a:stretch>
          </p:blipFill>
          <p:spPr bwMode="auto">
            <a:xfrm>
              <a:off x="1676400" y="5181600"/>
              <a:ext cx="1371600" cy="1219200"/>
            </a:xfrm>
            <a:prstGeom prst="rect">
              <a:avLst/>
            </a:prstGeom>
            <a:noFill/>
          </p:spPr>
        </p:pic>
        <p:pic>
          <p:nvPicPr>
            <p:cNvPr id="34843" name="Picture 27" descr="F:\chaithra education documents\IARI education\research work\PhD research photos\6869\6869\Chaetomium_011231_017.JPG"/>
            <p:cNvPicPr>
              <a:picLocks noChangeAspect="1" noChangeArrowheads="1"/>
            </p:cNvPicPr>
            <p:nvPr/>
          </p:nvPicPr>
          <p:blipFill>
            <a:blip r:embed="rId27" cstate="print"/>
            <a:srcRect/>
            <a:stretch>
              <a:fillRect/>
            </a:stretch>
          </p:blipFill>
          <p:spPr bwMode="auto">
            <a:xfrm>
              <a:off x="3048000" y="5181600"/>
              <a:ext cx="1447800" cy="1219200"/>
            </a:xfrm>
            <a:prstGeom prst="rect">
              <a:avLst/>
            </a:prstGeom>
            <a:noFill/>
          </p:spPr>
        </p:pic>
        <p:pic>
          <p:nvPicPr>
            <p:cNvPr id="34844" name="Picture 28" descr="F:\chaithra education documents\IARI education\research work\PhD research photos\7173\7173\beauveria001102_015.JPG"/>
            <p:cNvPicPr>
              <a:picLocks noChangeAspect="1" noChangeArrowheads="1"/>
            </p:cNvPicPr>
            <p:nvPr/>
          </p:nvPicPr>
          <p:blipFill>
            <a:blip r:embed="rId28" cstate="print"/>
            <a:srcRect/>
            <a:stretch>
              <a:fillRect/>
            </a:stretch>
          </p:blipFill>
          <p:spPr bwMode="auto">
            <a:xfrm>
              <a:off x="4495800" y="5181600"/>
              <a:ext cx="1371600" cy="1219200"/>
            </a:xfrm>
            <a:prstGeom prst="rect">
              <a:avLst/>
            </a:prstGeom>
            <a:noFill/>
          </p:spPr>
        </p:pic>
        <p:pic>
          <p:nvPicPr>
            <p:cNvPr id="34845" name="Picture 29" descr="F:\chaithra education documents\IARI education\research work\PhD research photos\7414\7414\beauveria011231_010.JPG"/>
            <p:cNvPicPr>
              <a:picLocks noChangeAspect="1" noChangeArrowheads="1"/>
            </p:cNvPicPr>
            <p:nvPr/>
          </p:nvPicPr>
          <p:blipFill>
            <a:blip r:embed="rId29" cstate="print"/>
            <a:srcRect/>
            <a:stretch>
              <a:fillRect/>
            </a:stretch>
          </p:blipFill>
          <p:spPr bwMode="auto">
            <a:xfrm>
              <a:off x="5867400" y="5181601"/>
              <a:ext cx="1371600" cy="1219200"/>
            </a:xfrm>
            <a:prstGeom prst="rect">
              <a:avLst/>
            </a:prstGeom>
            <a:noFill/>
          </p:spPr>
        </p:pic>
        <p:pic>
          <p:nvPicPr>
            <p:cNvPr id="34846" name="Picture 30" descr="F:\chaithra education documents\IARI education\research work\PhD research photos\7438\7438\beauveria011231_013.JPG"/>
            <p:cNvPicPr>
              <a:picLocks noChangeAspect="1" noChangeArrowheads="1"/>
            </p:cNvPicPr>
            <p:nvPr/>
          </p:nvPicPr>
          <p:blipFill>
            <a:blip r:embed="rId30" cstate="print"/>
            <a:srcRect/>
            <a:stretch>
              <a:fillRect/>
            </a:stretch>
          </p:blipFill>
          <p:spPr bwMode="auto">
            <a:xfrm>
              <a:off x="7239000" y="5181601"/>
              <a:ext cx="1295400" cy="1219200"/>
            </a:xfrm>
            <a:prstGeom prst="rect">
              <a:avLst/>
            </a:prstGeom>
            <a:noFill/>
          </p:spPr>
        </p:pic>
        <p:pic>
          <p:nvPicPr>
            <p:cNvPr id="34850" name="Picture 34" descr="F:\chaithra education documents\IARI education\research work\PhD research photos\913\913\beauveria011231_007.JPG"/>
            <p:cNvPicPr>
              <a:picLocks noChangeAspect="1" noChangeArrowheads="1"/>
            </p:cNvPicPr>
            <p:nvPr/>
          </p:nvPicPr>
          <p:blipFill>
            <a:blip r:embed="rId31" cstate="print"/>
            <a:srcRect/>
            <a:stretch>
              <a:fillRect/>
            </a:stretch>
          </p:blipFill>
          <p:spPr bwMode="auto">
            <a:xfrm>
              <a:off x="5867400" y="2743201"/>
              <a:ext cx="1371600" cy="1219200"/>
            </a:xfrm>
            <a:prstGeom prst="rect">
              <a:avLst/>
            </a:prstGeom>
            <a:noFill/>
          </p:spPr>
        </p:pic>
        <p:sp>
          <p:nvSpPr>
            <p:cNvPr id="32" name="TextBox 31"/>
            <p:cNvSpPr txBox="1"/>
            <p:nvPr/>
          </p:nvSpPr>
          <p:spPr>
            <a:xfrm>
              <a:off x="1371600" y="134779"/>
              <a:ext cx="4019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1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722266" y="152400"/>
              <a:ext cx="4019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2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4017666" y="181683"/>
              <a:ext cx="4019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3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465466" y="134779"/>
              <a:ext cx="4019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4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837066" y="181683"/>
              <a:ext cx="4019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5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8208666" y="152400"/>
              <a:ext cx="4019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6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236785" y="1506379"/>
              <a:ext cx="4019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7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646066" y="1506379"/>
              <a:ext cx="4019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8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461279" y="1447800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10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236785" y="27255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13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641879" y="27255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14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6832879" y="15063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11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093866" y="1506379"/>
              <a:ext cx="4019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9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091676" y="2725579"/>
              <a:ext cx="5565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15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236785" y="40209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19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441860" y="2725579"/>
              <a:ext cx="6541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16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832879" y="27255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17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8052079" y="27255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18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8128279" y="15063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12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2641879" y="51639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26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8052079" y="3962400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24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6832879" y="39447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23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385079" y="39447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22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013479" y="39447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21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641879" y="39447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20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013479" y="51639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27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5308879" y="5211050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28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6756679" y="51639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29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8128279" y="51639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30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236785" y="5163979"/>
              <a:ext cx="4823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Bb25</a:t>
              </a:r>
              <a:endParaRPr lang="en-US" sz="1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86" name="Title 1"/>
          <p:cNvSpPr txBox="1">
            <a:spLocks/>
          </p:cNvSpPr>
          <p:nvPr/>
        </p:nvSpPr>
        <p:spPr>
          <a:xfrm>
            <a:off x="533400" y="6248400"/>
            <a:ext cx="8229600" cy="4111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dirty="0" smtClean="0">
                <a:latin typeface="Times New Roman" pitchFamily="18" charset="0"/>
                <a:ea typeface="+mj-ea"/>
                <a:cs typeface="Times New Roman" pitchFamily="18" charset="0"/>
              </a:rPr>
              <a:t>Supplementary Figure 2: Conidial micrographs of thirty isolates of </a:t>
            </a:r>
            <a:r>
              <a:rPr lang="en-US" sz="1400" i="1" dirty="0" smtClean="0">
                <a:latin typeface="Times New Roman" pitchFamily="18" charset="0"/>
                <a:ea typeface="+mj-ea"/>
                <a:cs typeface="Times New Roman" pitchFamily="18" charset="0"/>
              </a:rPr>
              <a:t>B. </a:t>
            </a:r>
            <a:r>
              <a:rPr lang="en-US" sz="1400" i="1" dirty="0" err="1" smtClean="0">
                <a:latin typeface="Times New Roman" pitchFamily="18" charset="0"/>
                <a:ea typeface="+mj-ea"/>
                <a:cs typeface="Times New Roman" pitchFamily="18" charset="0"/>
              </a:rPr>
              <a:t>bassiana</a:t>
            </a:r>
            <a:r>
              <a:rPr lang="en-US" sz="1400" i="1" dirty="0" smtClean="0">
                <a:latin typeface="Times New Roman" pitchFamily="18" charset="0"/>
                <a:ea typeface="+mj-ea"/>
                <a:cs typeface="Times New Roman" pitchFamily="18" charset="0"/>
              </a:rPr>
              <a:t> </a:t>
            </a:r>
            <a:endParaRPr kumimoji="0" lang="en-US" sz="1400" b="0" i="1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Times New Roman" pitchFamily="18" charset="0"/>
              <a:ea typeface="+mj-ea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4"/>
          <p:cNvGrpSpPr/>
          <p:nvPr/>
        </p:nvGrpSpPr>
        <p:grpSpPr>
          <a:xfrm>
            <a:off x="381000" y="304800"/>
            <a:ext cx="8164598" cy="5603069"/>
            <a:chOff x="381000" y="304800"/>
            <a:chExt cx="8164598" cy="5603069"/>
          </a:xfrm>
        </p:grpSpPr>
        <p:pic>
          <p:nvPicPr>
            <p:cNvPr id="1026" name="Picture 2" descr="F:\chaithra education documents\IARI education\research work\Gel picture\ITS\its - Copy.jpg"/>
            <p:cNvPicPr>
              <a:picLocks noChangeAspect="1" noChangeArrowheads="1"/>
            </p:cNvPicPr>
            <p:nvPr/>
          </p:nvPicPr>
          <p:blipFill>
            <a:blip r:embed="rId2" cstate="print"/>
            <a:srcRect b="3439"/>
            <a:stretch>
              <a:fillRect/>
            </a:stretch>
          </p:blipFill>
          <p:spPr bwMode="auto">
            <a:xfrm>
              <a:off x="381000" y="304800"/>
              <a:ext cx="8153400" cy="2590800"/>
            </a:xfrm>
            <a:prstGeom prst="rect">
              <a:avLst/>
            </a:prstGeom>
            <a:noFill/>
          </p:spPr>
        </p:pic>
        <p:pic>
          <p:nvPicPr>
            <p:cNvPr id="1028" name="Picture 4" descr="F:\chaithra education documents\IARI education\research work\Gel picture\ITS\its - Copy (2)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81000" y="2971800"/>
              <a:ext cx="8153400" cy="2936069"/>
            </a:xfrm>
            <a:prstGeom prst="rect">
              <a:avLst/>
            </a:prstGeom>
            <a:noFill/>
          </p:spPr>
        </p:pic>
        <p:sp>
          <p:nvSpPr>
            <p:cNvPr id="6" name="TextBox 5"/>
            <p:cNvSpPr txBox="1"/>
            <p:nvPr/>
          </p:nvSpPr>
          <p:spPr>
            <a:xfrm>
              <a:off x="609600" y="381000"/>
              <a:ext cx="3064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M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967322" y="3810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177122" y="3810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6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828800" y="3810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3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371600" y="3810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286000" y="3810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4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719922" y="3810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5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410200" y="3810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1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953000" y="3810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0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548722" y="3810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9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091522" y="3810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8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634322" y="3810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7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077200" y="3810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7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620000" y="3810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6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162800" y="3810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5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705600" y="3810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4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248400" y="3810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3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867400" y="3810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2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33400" y="3200400"/>
              <a:ext cx="3064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M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055602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8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798802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3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122402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0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589002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9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732002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1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265402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2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618202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8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019800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7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5475202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6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941802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5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4332202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4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7685002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30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151602" y="32004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9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457200" y="6172200"/>
            <a:ext cx="80772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upplementary Figure 3 : PCR amplification patterns in ITS1-5.8S-ITS2 with ITS1/ITS4 primers from thirty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bassian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 isolates; L is 1000-bp DNA ladder.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33400" y="6019800"/>
            <a:ext cx="78486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4 : PCR amplification patterns in TEF with EF1-983/EF1-2218 primers from thirty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bassian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 isolates; L is 1000-bp DNA ladder.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967322" y="381000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Bb1</a:t>
            </a:r>
            <a:endParaRPr lang="en-US" sz="10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371600" y="381000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Bb2</a:t>
            </a:r>
            <a:endParaRPr lang="en-US" sz="10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5410200" y="38100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Bb11</a:t>
            </a:r>
            <a:endParaRPr lang="en-US" sz="10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548722" y="381000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Bb9</a:t>
            </a:r>
            <a:endParaRPr lang="en-US" sz="10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634322" y="381000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Bb7</a:t>
            </a:r>
            <a:endParaRPr lang="en-US" sz="10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89"/>
          <p:cNvGrpSpPr/>
          <p:nvPr/>
        </p:nvGrpSpPr>
        <p:grpSpPr>
          <a:xfrm>
            <a:off x="533400" y="685800"/>
            <a:ext cx="8012198" cy="5181600"/>
            <a:chOff x="533400" y="685800"/>
            <a:chExt cx="8012198" cy="5181600"/>
          </a:xfrm>
        </p:grpSpPr>
        <p:pic>
          <p:nvPicPr>
            <p:cNvPr id="2050" name="Picture 2" descr="F:\chaithra education documents\IARI education\research work\Gel picture\TEF\FINAL TEF - Copy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533400" y="685800"/>
              <a:ext cx="8001000" cy="2394573"/>
            </a:xfrm>
            <a:prstGeom prst="rect">
              <a:avLst/>
            </a:prstGeom>
            <a:noFill/>
          </p:spPr>
        </p:pic>
        <p:pic>
          <p:nvPicPr>
            <p:cNvPr id="2051" name="Picture 3" descr="F:\chaithra education documents\IARI education\research work\Gel picture\TEF\FINAL TEF - Copy - Copy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533400" y="3200400"/>
              <a:ext cx="8001000" cy="2667000"/>
            </a:xfrm>
            <a:prstGeom prst="rect">
              <a:avLst/>
            </a:prstGeom>
            <a:noFill/>
          </p:spPr>
        </p:pic>
        <p:sp>
          <p:nvSpPr>
            <p:cNvPr id="58" name="TextBox 57"/>
            <p:cNvSpPr txBox="1"/>
            <p:nvPr/>
          </p:nvSpPr>
          <p:spPr>
            <a:xfrm>
              <a:off x="685800" y="3258979"/>
              <a:ext cx="3064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M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208002" y="3258979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8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4027402" y="3258979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3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351002" y="3258979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0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817602" y="32766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9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2884402" y="3258979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1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417802" y="3258979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2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6858000" y="32766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8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6324600" y="3258979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7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5780002" y="3258979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6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5170402" y="3258979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5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4637002" y="3258979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4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8001000" y="32766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30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7456402" y="32766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9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609600" y="838200"/>
              <a:ext cx="3064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M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990600" y="8382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276600" y="8382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6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881722" y="8382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3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424522" y="8382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362200" y="8382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4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819400" y="8382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5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5410200" y="838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1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5029200" y="838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0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4648200" y="8382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9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4191000" y="8382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8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3733800" y="838200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7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8077200" y="838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7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7620000" y="838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6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7162800" y="838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5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6770602" y="838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4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6313402" y="838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3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5867400" y="838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2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609600" y="381000"/>
            <a:ext cx="30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M</a:t>
            </a:r>
            <a:endParaRPr lang="en-US" sz="10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286000" y="381000"/>
            <a:ext cx="4042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Bb4</a:t>
            </a:r>
            <a:endParaRPr lang="en-US" sz="10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7162800" y="38100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Bb15</a:t>
            </a:r>
            <a:endParaRPr lang="en-US" sz="10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6705600" y="38100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Bb14</a:t>
            </a:r>
            <a:endParaRPr lang="en-US" sz="10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33400" y="3200400"/>
            <a:ext cx="3064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rPr>
              <a:t>M</a:t>
            </a:r>
            <a:endParaRPr lang="en-US" sz="1000" b="1" dirty="0">
              <a:solidFill>
                <a:schemeClr val="bg1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59"/>
          <p:cNvGrpSpPr/>
          <p:nvPr/>
        </p:nvGrpSpPr>
        <p:grpSpPr>
          <a:xfrm>
            <a:off x="762000" y="838200"/>
            <a:ext cx="7809023" cy="4848220"/>
            <a:chOff x="685800" y="714380"/>
            <a:chExt cx="7809023" cy="4848220"/>
          </a:xfrm>
        </p:grpSpPr>
        <p:pic>
          <p:nvPicPr>
            <p:cNvPr id="5122" name="Picture 2" descr="F:\chaithra education documents\IARI education\research work\Gel picture\Chitinase\chitinase - final - Copy.jpg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685800" y="714380"/>
              <a:ext cx="7772400" cy="2333620"/>
            </a:xfrm>
            <a:prstGeom prst="rect">
              <a:avLst/>
            </a:prstGeom>
            <a:noFill/>
          </p:spPr>
        </p:pic>
        <p:pic>
          <p:nvPicPr>
            <p:cNvPr id="5123" name="Picture 3" descr="F:\chaithra education documents\IARI education\research work\Gel picture\Chitinase\chitinase - final - Copy (2).jpg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762000" y="3124200"/>
              <a:ext cx="7732823" cy="2438400"/>
            </a:xfrm>
            <a:prstGeom prst="rect">
              <a:avLst/>
            </a:prstGeom>
            <a:noFill/>
          </p:spPr>
        </p:pic>
        <p:sp>
          <p:nvSpPr>
            <p:cNvPr id="27" name="TextBox 26"/>
            <p:cNvSpPr txBox="1"/>
            <p:nvPr/>
          </p:nvSpPr>
          <p:spPr>
            <a:xfrm>
              <a:off x="1371600" y="3124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8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4114800" y="3124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3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503402" y="3124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0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905000" y="3124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9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971800" y="3124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1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581400" y="3124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2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858000" y="3124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8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248400" y="3124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7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715000" y="3124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6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181600" y="3124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5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648200" y="3124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4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913602" y="3106579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30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7380202" y="3124200"/>
              <a:ext cx="4683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9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838632" y="759564"/>
              <a:ext cx="304368" cy="2462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M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143000" y="759564"/>
              <a:ext cx="4014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3276600" y="759564"/>
              <a:ext cx="4014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6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981200" y="741943"/>
              <a:ext cx="4014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3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600200" y="759564"/>
              <a:ext cx="4014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2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438400" y="759564"/>
              <a:ext cx="4014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4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873724" y="759564"/>
              <a:ext cx="4014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5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400624" y="759564"/>
              <a:ext cx="4651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1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4954622" y="759564"/>
              <a:ext cx="4651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0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573402" y="759564"/>
              <a:ext cx="4014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9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116202" y="759564"/>
              <a:ext cx="4014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8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711924" y="759564"/>
              <a:ext cx="4014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7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7916846" y="759564"/>
              <a:ext cx="4651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7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7467600" y="759564"/>
              <a:ext cx="4651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6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7086600" y="759564"/>
              <a:ext cx="4651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5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697646" y="759564"/>
              <a:ext cx="4651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4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6238824" y="759564"/>
              <a:ext cx="4651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3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792822" y="759564"/>
              <a:ext cx="4651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Bb12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912706" y="3124200"/>
              <a:ext cx="3064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rPr>
                <a:t>M</a:t>
              </a:r>
              <a:endParaRPr lang="en-US" sz="1000" b="1" dirty="0">
                <a:solidFill>
                  <a:schemeClr val="bg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61" name="Rectangle 60"/>
          <p:cNvSpPr/>
          <p:nvPr/>
        </p:nvSpPr>
        <p:spPr>
          <a:xfrm>
            <a:off x="762000" y="5715001"/>
            <a:ext cx="76962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5 : PCR amplification patterns in Bbchit1 with 526ChitEcoR1/325ChitHindIII primers from thirty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bassian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 isolates; L is 1000-bp DNA ladder.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04800" y="5791200"/>
            <a:ext cx="88392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0" algn="just">
              <a:buNone/>
            </a:pP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igure 6: Phylogenetic analysis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bassiana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isolates based on combined partial ITS+TEF+Bbchit1 sequences. The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endrogram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was constructed by using Neighbor-Joining method with the Tamura-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Nei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model with MEGA 10 version. Isolate representing ex-type material is marked with “T”. Bootstrap values shown next to nodes are based on 1,000 replicates. The tree was rooted using isolate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Metarhizium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anisopliae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E6 as the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outgroup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.</a:t>
            </a:r>
          </a:p>
        </p:txBody>
      </p:sp>
      <p:pic>
        <p:nvPicPr>
          <p:cNvPr id="6" name="Picture 5"/>
          <p:cNvPicPr/>
          <p:nvPr/>
        </p:nvPicPr>
        <p:blipFill>
          <a:blip r:embed="rId2" cstate="print"/>
          <a:srcRect l="2564" r="3846" b="3385"/>
          <a:stretch>
            <a:fillRect/>
          </a:stretch>
        </p:blipFill>
        <p:spPr bwMode="auto">
          <a:xfrm>
            <a:off x="1676400" y="304800"/>
            <a:ext cx="5638800" cy="525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81000" y="5562600"/>
            <a:ext cx="876300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indent="0" algn="just">
              <a:buNone/>
            </a:pP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Supplementary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igure 7: Phylogenetic analysis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bassiana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isolates based on combined partial ITS+TEF+Bbchit1 sequences. The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dendrogram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was constructed by using minimum evolution method with the Tamura-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Nei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model with MEGA 10 version. Isolate representing ex-type material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is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marked with “T”. Bootstrap values shown next to nodes are based on 1,000 replicates. The tree was rooted using isolate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Metarhizium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anisopliae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E6 as the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outgroup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.</a:t>
            </a:r>
          </a:p>
        </p:txBody>
      </p:sp>
      <p:pic>
        <p:nvPicPr>
          <p:cNvPr id="6" name="Picture 5"/>
          <p:cNvPicPr/>
          <p:nvPr/>
        </p:nvPicPr>
        <p:blipFill>
          <a:blip r:embed="rId2" cstate="print"/>
          <a:srcRect l="2564" r="3846" b="5350"/>
          <a:stretch>
            <a:fillRect/>
          </a:stretch>
        </p:blipFill>
        <p:spPr bwMode="auto">
          <a:xfrm>
            <a:off x="1752600" y="304800"/>
            <a:ext cx="5562600" cy="5168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B2004FFD-A690-444B-A4AB-F237599C0847}"/>
              </a:ext>
            </a:extLst>
          </p:cNvPr>
          <p:cNvGraphicFramePr/>
          <p:nvPr/>
        </p:nvGraphicFramePr>
        <p:xfrm>
          <a:off x="1066800" y="1371600"/>
          <a:ext cx="6955831" cy="38331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762001" y="5380672"/>
            <a:ext cx="739139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8: Corrected mortality (%) of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T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truncatus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by different 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400" i="1" dirty="0" err="1" smtClean="0">
                <a:latin typeface="Times New Roman" pitchFamily="18" charset="0"/>
                <a:cs typeface="Times New Roman" pitchFamily="18" charset="0"/>
              </a:rPr>
              <a:t>bassiana</a:t>
            </a:r>
            <a:r>
              <a:rPr lang="en-US" sz="14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isolates after different intervals post infection. (A) 3DAI, (B) 5 DAI, C) 7 DAI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</TotalTime>
  <Words>570</Words>
  <Application>Microsoft Office PowerPoint</Application>
  <PresentationFormat>On-screen Show (4:3)</PresentationFormat>
  <Paragraphs>208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c</dc:creator>
  <cp:lastModifiedBy>Chaithra</cp:lastModifiedBy>
  <cp:revision>14</cp:revision>
  <dcterms:created xsi:type="dcterms:W3CDTF">2006-08-16T00:00:00Z</dcterms:created>
  <dcterms:modified xsi:type="dcterms:W3CDTF">2022-07-29T18:13:35Z</dcterms:modified>
</cp:coreProperties>
</file>